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9" r:id="rId4"/>
    <p:sldId id="260" r:id="rId5"/>
  </p:sldIdLst>
  <p:sldSz cx="7556500" cy="106934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16.png"/><Relationship Id="rId7" Type="http://schemas.openxmlformats.org/officeDocument/2006/relationships/image" Target="../media/image15.png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16.png"/><Relationship Id="rId7" Type="http://schemas.openxmlformats.org/officeDocument/2006/relationships/image" Target="../media/image15.png"/><Relationship Id="rId6" Type="http://schemas.openxmlformats.org/officeDocument/2006/relationships/image" Target="../media/image14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ath"/>
          <p:cNvSpPr/>
          <p:nvPr/>
        </p:nvSpPr>
        <p:spPr>
          <a:xfrm>
            <a:off x="924574" y="3796438"/>
            <a:ext cx="3620944" cy="109340"/>
          </a:xfrm>
          <a:custGeom>
            <a:avLst/>
            <a:gdLst/>
            <a:ahLst/>
            <a:cxnLst/>
            <a:rect l="0" t="0" r="0" b="0"/>
            <a:pathLst>
              <a:path w="5702" h="172">
                <a:moveTo>
                  <a:pt x="7" y="164"/>
                </a:moveTo>
                <a:lnTo>
                  <a:pt x="35" y="164"/>
                </a:lnTo>
                <a:lnTo>
                  <a:pt x="64" y="164"/>
                </a:lnTo>
                <a:lnTo>
                  <a:pt x="92" y="164"/>
                </a:lnTo>
                <a:lnTo>
                  <a:pt x="121" y="164"/>
                </a:lnTo>
                <a:lnTo>
                  <a:pt x="149" y="164"/>
                </a:lnTo>
                <a:lnTo>
                  <a:pt x="177" y="164"/>
                </a:lnTo>
                <a:lnTo>
                  <a:pt x="206" y="164"/>
                </a:lnTo>
                <a:lnTo>
                  <a:pt x="234" y="164"/>
                </a:lnTo>
                <a:lnTo>
                  <a:pt x="263" y="164"/>
                </a:lnTo>
                <a:lnTo>
                  <a:pt x="291" y="164"/>
                </a:lnTo>
                <a:lnTo>
                  <a:pt x="320" y="164"/>
                </a:lnTo>
                <a:lnTo>
                  <a:pt x="348" y="164"/>
                </a:lnTo>
                <a:lnTo>
                  <a:pt x="376" y="164"/>
                </a:lnTo>
                <a:lnTo>
                  <a:pt x="405" y="164"/>
                </a:lnTo>
                <a:lnTo>
                  <a:pt x="433" y="164"/>
                </a:lnTo>
                <a:lnTo>
                  <a:pt x="462" y="164"/>
                </a:lnTo>
                <a:lnTo>
                  <a:pt x="490" y="164"/>
                </a:lnTo>
                <a:lnTo>
                  <a:pt x="519" y="164"/>
                </a:lnTo>
                <a:lnTo>
                  <a:pt x="547" y="164"/>
                </a:lnTo>
                <a:lnTo>
                  <a:pt x="576" y="164"/>
                </a:lnTo>
                <a:lnTo>
                  <a:pt x="604" y="164"/>
                </a:lnTo>
                <a:lnTo>
                  <a:pt x="632" y="164"/>
                </a:lnTo>
                <a:lnTo>
                  <a:pt x="661" y="164"/>
                </a:lnTo>
                <a:lnTo>
                  <a:pt x="689" y="164"/>
                </a:lnTo>
                <a:lnTo>
                  <a:pt x="718" y="164"/>
                </a:lnTo>
                <a:lnTo>
                  <a:pt x="746" y="164"/>
                </a:lnTo>
                <a:lnTo>
                  <a:pt x="775" y="164"/>
                </a:lnTo>
                <a:lnTo>
                  <a:pt x="803" y="164"/>
                </a:lnTo>
                <a:lnTo>
                  <a:pt x="832" y="164"/>
                </a:lnTo>
                <a:lnTo>
                  <a:pt x="860" y="164"/>
                </a:lnTo>
                <a:lnTo>
                  <a:pt x="888" y="164"/>
                </a:lnTo>
                <a:lnTo>
                  <a:pt x="917" y="164"/>
                </a:lnTo>
                <a:lnTo>
                  <a:pt x="945" y="164"/>
                </a:lnTo>
                <a:lnTo>
                  <a:pt x="974" y="164"/>
                </a:lnTo>
                <a:lnTo>
                  <a:pt x="1002" y="164"/>
                </a:lnTo>
                <a:lnTo>
                  <a:pt x="1031" y="164"/>
                </a:lnTo>
                <a:lnTo>
                  <a:pt x="1059" y="164"/>
                </a:lnTo>
                <a:lnTo>
                  <a:pt x="1087" y="164"/>
                </a:lnTo>
                <a:lnTo>
                  <a:pt x="1116" y="164"/>
                </a:lnTo>
                <a:lnTo>
                  <a:pt x="1144" y="164"/>
                </a:lnTo>
                <a:lnTo>
                  <a:pt x="1173" y="164"/>
                </a:lnTo>
                <a:lnTo>
                  <a:pt x="1201" y="164"/>
                </a:lnTo>
                <a:lnTo>
                  <a:pt x="1230" y="163"/>
                </a:lnTo>
                <a:lnTo>
                  <a:pt x="1258" y="160"/>
                </a:lnTo>
                <a:lnTo>
                  <a:pt x="1287" y="161"/>
                </a:lnTo>
                <a:lnTo>
                  <a:pt x="1315" y="160"/>
                </a:lnTo>
                <a:lnTo>
                  <a:pt x="1343" y="159"/>
                </a:lnTo>
                <a:lnTo>
                  <a:pt x="1372" y="161"/>
                </a:lnTo>
                <a:lnTo>
                  <a:pt x="1400" y="159"/>
                </a:lnTo>
                <a:lnTo>
                  <a:pt x="1429" y="159"/>
                </a:lnTo>
                <a:lnTo>
                  <a:pt x="1457" y="160"/>
                </a:lnTo>
                <a:lnTo>
                  <a:pt x="1486" y="161"/>
                </a:lnTo>
                <a:lnTo>
                  <a:pt x="1514" y="155"/>
                </a:lnTo>
                <a:lnTo>
                  <a:pt x="1542" y="157"/>
                </a:lnTo>
                <a:lnTo>
                  <a:pt x="1571" y="158"/>
                </a:lnTo>
                <a:lnTo>
                  <a:pt x="1599" y="159"/>
                </a:lnTo>
                <a:lnTo>
                  <a:pt x="1628" y="156"/>
                </a:lnTo>
                <a:lnTo>
                  <a:pt x="1656" y="157"/>
                </a:lnTo>
                <a:lnTo>
                  <a:pt x="1685" y="151"/>
                </a:lnTo>
                <a:lnTo>
                  <a:pt x="1713" y="144"/>
                </a:lnTo>
                <a:lnTo>
                  <a:pt x="1742" y="134"/>
                </a:lnTo>
                <a:lnTo>
                  <a:pt x="1770" y="113"/>
                </a:lnTo>
                <a:lnTo>
                  <a:pt x="1798" y="71"/>
                </a:lnTo>
                <a:lnTo>
                  <a:pt x="1827" y="7"/>
                </a:lnTo>
                <a:moveTo>
                  <a:pt x="2282" y="60"/>
                </a:moveTo>
                <a:lnTo>
                  <a:pt x="2310" y="104"/>
                </a:lnTo>
                <a:lnTo>
                  <a:pt x="2339" y="117"/>
                </a:lnTo>
                <a:lnTo>
                  <a:pt x="2367" y="129"/>
                </a:lnTo>
                <a:lnTo>
                  <a:pt x="2396" y="130"/>
                </a:lnTo>
                <a:lnTo>
                  <a:pt x="2424" y="138"/>
                </a:lnTo>
                <a:lnTo>
                  <a:pt x="2452" y="134"/>
                </a:lnTo>
                <a:lnTo>
                  <a:pt x="2481" y="148"/>
                </a:lnTo>
                <a:lnTo>
                  <a:pt x="2509" y="143"/>
                </a:lnTo>
                <a:lnTo>
                  <a:pt x="2538" y="140"/>
                </a:lnTo>
                <a:lnTo>
                  <a:pt x="2566" y="144"/>
                </a:lnTo>
                <a:lnTo>
                  <a:pt x="2595" y="142"/>
                </a:lnTo>
                <a:lnTo>
                  <a:pt x="2623" y="145"/>
                </a:lnTo>
                <a:lnTo>
                  <a:pt x="2652" y="149"/>
                </a:lnTo>
                <a:lnTo>
                  <a:pt x="2680" y="147"/>
                </a:lnTo>
                <a:lnTo>
                  <a:pt x="2708" y="147"/>
                </a:lnTo>
                <a:lnTo>
                  <a:pt x="2737" y="148"/>
                </a:lnTo>
                <a:lnTo>
                  <a:pt x="2765" y="148"/>
                </a:lnTo>
                <a:lnTo>
                  <a:pt x="2794" y="158"/>
                </a:lnTo>
                <a:lnTo>
                  <a:pt x="2822" y="152"/>
                </a:lnTo>
                <a:lnTo>
                  <a:pt x="2851" y="150"/>
                </a:lnTo>
                <a:lnTo>
                  <a:pt x="2879" y="146"/>
                </a:lnTo>
                <a:lnTo>
                  <a:pt x="2908" y="152"/>
                </a:lnTo>
                <a:lnTo>
                  <a:pt x="2936" y="148"/>
                </a:lnTo>
                <a:lnTo>
                  <a:pt x="2964" y="143"/>
                </a:lnTo>
                <a:lnTo>
                  <a:pt x="2993" y="154"/>
                </a:lnTo>
                <a:lnTo>
                  <a:pt x="3021" y="152"/>
                </a:lnTo>
                <a:lnTo>
                  <a:pt x="3050" y="150"/>
                </a:lnTo>
                <a:lnTo>
                  <a:pt x="3078" y="144"/>
                </a:lnTo>
                <a:lnTo>
                  <a:pt x="3107" y="138"/>
                </a:lnTo>
                <a:lnTo>
                  <a:pt x="3135" y="155"/>
                </a:lnTo>
                <a:lnTo>
                  <a:pt x="3163" y="150"/>
                </a:lnTo>
                <a:lnTo>
                  <a:pt x="3192" y="148"/>
                </a:lnTo>
                <a:lnTo>
                  <a:pt x="3220" y="149"/>
                </a:lnTo>
                <a:lnTo>
                  <a:pt x="3249" y="145"/>
                </a:lnTo>
                <a:lnTo>
                  <a:pt x="3277" y="154"/>
                </a:lnTo>
                <a:lnTo>
                  <a:pt x="3306" y="154"/>
                </a:lnTo>
                <a:lnTo>
                  <a:pt x="3334" y="151"/>
                </a:lnTo>
                <a:lnTo>
                  <a:pt x="3363" y="149"/>
                </a:lnTo>
                <a:lnTo>
                  <a:pt x="3391" y="150"/>
                </a:lnTo>
                <a:lnTo>
                  <a:pt x="3419" y="144"/>
                </a:lnTo>
                <a:lnTo>
                  <a:pt x="3448" y="145"/>
                </a:lnTo>
                <a:lnTo>
                  <a:pt x="3476" y="151"/>
                </a:lnTo>
                <a:lnTo>
                  <a:pt x="3505" y="152"/>
                </a:lnTo>
                <a:lnTo>
                  <a:pt x="3533" y="136"/>
                </a:lnTo>
                <a:lnTo>
                  <a:pt x="3562" y="156"/>
                </a:lnTo>
                <a:lnTo>
                  <a:pt x="3590" y="146"/>
                </a:lnTo>
                <a:lnTo>
                  <a:pt x="3618" y="144"/>
                </a:lnTo>
                <a:lnTo>
                  <a:pt x="3647" y="129"/>
                </a:lnTo>
                <a:lnTo>
                  <a:pt x="3675" y="146"/>
                </a:lnTo>
                <a:lnTo>
                  <a:pt x="3704" y="126"/>
                </a:lnTo>
                <a:lnTo>
                  <a:pt x="3732" y="130"/>
                </a:lnTo>
                <a:lnTo>
                  <a:pt x="3761" y="140"/>
                </a:lnTo>
                <a:lnTo>
                  <a:pt x="3789" y="124"/>
                </a:lnTo>
                <a:lnTo>
                  <a:pt x="3818" y="117"/>
                </a:lnTo>
                <a:lnTo>
                  <a:pt x="3846" y="99"/>
                </a:lnTo>
                <a:lnTo>
                  <a:pt x="3874" y="90"/>
                </a:lnTo>
                <a:lnTo>
                  <a:pt x="3903" y="93"/>
                </a:lnTo>
                <a:lnTo>
                  <a:pt x="3931" y="83"/>
                </a:lnTo>
                <a:lnTo>
                  <a:pt x="3960" y="64"/>
                </a:lnTo>
                <a:lnTo>
                  <a:pt x="3988" y="68"/>
                </a:lnTo>
                <a:lnTo>
                  <a:pt x="4017" y="42"/>
                </a:lnTo>
                <a:lnTo>
                  <a:pt x="4045" y="22"/>
                </a:lnTo>
                <a:lnTo>
                  <a:pt x="4073" y="24"/>
                </a:lnTo>
                <a:lnTo>
                  <a:pt x="4102" y="15"/>
                </a:lnTo>
                <a:lnTo>
                  <a:pt x="4130" y="11"/>
                </a:lnTo>
                <a:lnTo>
                  <a:pt x="4159" y="19"/>
                </a:lnTo>
                <a:lnTo>
                  <a:pt x="4187" y="26"/>
                </a:lnTo>
                <a:lnTo>
                  <a:pt x="4216" y="51"/>
                </a:lnTo>
                <a:lnTo>
                  <a:pt x="4244" y="74"/>
                </a:lnTo>
                <a:lnTo>
                  <a:pt x="4273" y="107"/>
                </a:lnTo>
                <a:lnTo>
                  <a:pt x="4301" y="123"/>
                </a:lnTo>
                <a:lnTo>
                  <a:pt x="4329" y="142"/>
                </a:lnTo>
                <a:lnTo>
                  <a:pt x="4358" y="147"/>
                </a:lnTo>
                <a:lnTo>
                  <a:pt x="4386" y="156"/>
                </a:lnTo>
                <a:lnTo>
                  <a:pt x="4415" y="156"/>
                </a:lnTo>
                <a:lnTo>
                  <a:pt x="4443" y="157"/>
                </a:lnTo>
                <a:lnTo>
                  <a:pt x="4472" y="163"/>
                </a:lnTo>
                <a:lnTo>
                  <a:pt x="4500" y="163"/>
                </a:lnTo>
                <a:lnTo>
                  <a:pt x="4529" y="161"/>
                </a:lnTo>
                <a:lnTo>
                  <a:pt x="4557" y="164"/>
                </a:lnTo>
                <a:lnTo>
                  <a:pt x="4585" y="163"/>
                </a:lnTo>
                <a:lnTo>
                  <a:pt x="4614" y="162"/>
                </a:lnTo>
                <a:lnTo>
                  <a:pt x="4642" y="163"/>
                </a:lnTo>
                <a:lnTo>
                  <a:pt x="4671" y="162"/>
                </a:lnTo>
                <a:lnTo>
                  <a:pt x="4699" y="164"/>
                </a:lnTo>
                <a:lnTo>
                  <a:pt x="4728" y="164"/>
                </a:lnTo>
                <a:lnTo>
                  <a:pt x="4756" y="162"/>
                </a:lnTo>
                <a:lnTo>
                  <a:pt x="4784" y="162"/>
                </a:lnTo>
                <a:lnTo>
                  <a:pt x="4813" y="163"/>
                </a:lnTo>
                <a:lnTo>
                  <a:pt x="4841" y="164"/>
                </a:lnTo>
                <a:lnTo>
                  <a:pt x="4870" y="161"/>
                </a:lnTo>
                <a:lnTo>
                  <a:pt x="4898" y="161"/>
                </a:lnTo>
                <a:lnTo>
                  <a:pt x="4927" y="161"/>
                </a:lnTo>
                <a:lnTo>
                  <a:pt x="4955" y="164"/>
                </a:lnTo>
                <a:lnTo>
                  <a:pt x="4984" y="164"/>
                </a:lnTo>
                <a:lnTo>
                  <a:pt x="5012" y="164"/>
                </a:lnTo>
                <a:lnTo>
                  <a:pt x="5040" y="164"/>
                </a:lnTo>
                <a:lnTo>
                  <a:pt x="5069" y="163"/>
                </a:lnTo>
                <a:lnTo>
                  <a:pt x="5097" y="164"/>
                </a:lnTo>
                <a:lnTo>
                  <a:pt x="5126" y="164"/>
                </a:lnTo>
                <a:lnTo>
                  <a:pt x="5154" y="163"/>
                </a:lnTo>
                <a:lnTo>
                  <a:pt x="5183" y="164"/>
                </a:lnTo>
                <a:lnTo>
                  <a:pt x="5211" y="163"/>
                </a:lnTo>
                <a:lnTo>
                  <a:pt x="5239" y="163"/>
                </a:lnTo>
                <a:lnTo>
                  <a:pt x="5268" y="164"/>
                </a:lnTo>
                <a:lnTo>
                  <a:pt x="5296" y="164"/>
                </a:lnTo>
                <a:lnTo>
                  <a:pt x="5325" y="164"/>
                </a:lnTo>
                <a:lnTo>
                  <a:pt x="5353" y="164"/>
                </a:lnTo>
                <a:lnTo>
                  <a:pt x="5382" y="164"/>
                </a:lnTo>
                <a:lnTo>
                  <a:pt x="5410" y="164"/>
                </a:lnTo>
                <a:lnTo>
                  <a:pt x="5439" y="164"/>
                </a:lnTo>
                <a:lnTo>
                  <a:pt x="5467" y="164"/>
                </a:lnTo>
                <a:lnTo>
                  <a:pt x="5495" y="164"/>
                </a:lnTo>
                <a:lnTo>
                  <a:pt x="5524" y="164"/>
                </a:lnTo>
                <a:lnTo>
                  <a:pt x="5552" y="164"/>
                </a:lnTo>
                <a:lnTo>
                  <a:pt x="5581" y="164"/>
                </a:lnTo>
                <a:lnTo>
                  <a:pt x="5609" y="164"/>
                </a:lnTo>
                <a:lnTo>
                  <a:pt x="5638" y="164"/>
                </a:lnTo>
                <a:lnTo>
                  <a:pt x="5666" y="164"/>
                </a:lnTo>
                <a:lnTo>
                  <a:pt x="5694" y="164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" name="path"/>
          <p:cNvSpPr/>
          <p:nvPr/>
        </p:nvSpPr>
        <p:spPr>
          <a:xfrm>
            <a:off x="1093478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" name="path"/>
          <p:cNvSpPr/>
          <p:nvPr/>
        </p:nvSpPr>
        <p:spPr>
          <a:xfrm>
            <a:off x="2902882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" name="path"/>
          <p:cNvSpPr/>
          <p:nvPr/>
        </p:nvSpPr>
        <p:spPr>
          <a:xfrm>
            <a:off x="915387" y="3900191"/>
            <a:ext cx="7123" cy="135349"/>
          </a:xfrm>
          <a:custGeom>
            <a:avLst/>
            <a:gdLst/>
            <a:ahLst/>
            <a:cxnLst/>
            <a:rect l="0" t="0" r="0" b="0"/>
            <a:pathLst>
              <a:path w="11" h="213">
                <a:moveTo>
                  <a:pt x="5" y="5"/>
                </a:moveTo>
                <a:lnTo>
                  <a:pt x="5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" name="path"/>
          <p:cNvSpPr/>
          <p:nvPr/>
        </p:nvSpPr>
        <p:spPr>
          <a:xfrm>
            <a:off x="1998180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" name="path"/>
          <p:cNvSpPr/>
          <p:nvPr/>
        </p:nvSpPr>
        <p:spPr>
          <a:xfrm>
            <a:off x="3807583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14" name="picture 1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2206777" y="3768830"/>
            <a:ext cx="171731" cy="247008"/>
          </a:xfrm>
          <a:prstGeom prst="rect">
            <a:avLst/>
          </a:prstGeom>
        </p:spPr>
      </p:pic>
      <p:pic>
        <p:nvPicPr>
          <p:cNvPr id="16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3488925" y="3899554"/>
            <a:ext cx="117499" cy="116283"/>
          </a:xfrm>
          <a:prstGeom prst="rect">
            <a:avLst/>
          </a:prstGeom>
        </p:spPr>
      </p:pic>
      <p:sp>
        <p:nvSpPr>
          <p:cNvPr id="18" name="path"/>
          <p:cNvSpPr/>
          <p:nvPr/>
        </p:nvSpPr>
        <p:spPr>
          <a:xfrm>
            <a:off x="915387" y="3900191"/>
            <a:ext cx="3625931" cy="7123"/>
          </a:xfrm>
          <a:custGeom>
            <a:avLst/>
            <a:gdLst/>
            <a:ahLst/>
            <a:cxnLst/>
            <a:rect l="0" t="0" r="0" b="0"/>
            <a:pathLst>
              <a:path w="5710" h="11">
                <a:moveTo>
                  <a:pt x="5" y="5"/>
                </a:moveTo>
                <a:lnTo>
                  <a:pt x="5704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" name="path"/>
          <p:cNvSpPr/>
          <p:nvPr/>
        </p:nvSpPr>
        <p:spPr>
          <a:xfrm>
            <a:off x="2080313" y="875507"/>
            <a:ext cx="280136" cy="2930193"/>
          </a:xfrm>
          <a:custGeom>
            <a:avLst/>
            <a:gdLst/>
            <a:ahLst/>
            <a:cxnLst/>
            <a:rect l="0" t="0" r="0" b="0"/>
            <a:pathLst>
              <a:path w="441" h="4614">
                <a:moveTo>
                  <a:pt x="7" y="4607"/>
                </a:moveTo>
                <a:lnTo>
                  <a:pt x="35" y="4497"/>
                </a:lnTo>
                <a:lnTo>
                  <a:pt x="64" y="4325"/>
                </a:lnTo>
                <a:lnTo>
                  <a:pt x="92" y="4106"/>
                </a:lnTo>
                <a:lnTo>
                  <a:pt x="121" y="3903"/>
                </a:lnTo>
                <a:lnTo>
                  <a:pt x="149" y="3403"/>
                </a:lnTo>
                <a:lnTo>
                  <a:pt x="177" y="2898"/>
                </a:lnTo>
                <a:lnTo>
                  <a:pt x="206" y="2298"/>
                </a:lnTo>
                <a:lnTo>
                  <a:pt x="234" y="1399"/>
                </a:lnTo>
                <a:lnTo>
                  <a:pt x="263" y="552"/>
                </a:lnTo>
                <a:lnTo>
                  <a:pt x="291" y="7"/>
                </a:lnTo>
                <a:lnTo>
                  <a:pt x="320" y="694"/>
                </a:lnTo>
                <a:lnTo>
                  <a:pt x="348" y="2238"/>
                </a:lnTo>
                <a:lnTo>
                  <a:pt x="376" y="3581"/>
                </a:lnTo>
                <a:lnTo>
                  <a:pt x="405" y="4245"/>
                </a:lnTo>
                <a:lnTo>
                  <a:pt x="433" y="4563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22" name="picture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929204" y="1224514"/>
            <a:ext cx="3611684" cy="2676634"/>
          </a:xfrm>
          <a:prstGeom prst="rect">
            <a:avLst/>
          </a:prstGeom>
        </p:spPr>
      </p:pic>
      <p:sp>
        <p:nvSpPr>
          <p:cNvPr id="24" name="textbox 24"/>
          <p:cNvSpPr/>
          <p:nvPr/>
        </p:nvSpPr>
        <p:spPr>
          <a:xfrm>
            <a:off x="5148708" y="463314"/>
            <a:ext cx="2123439" cy="33096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8000"/>
              </a:lnSpc>
            </a:pPr>
            <a:endParaRPr lang="en-US" altLang="en-US" sz="100" dirty="0"/>
          </a:p>
          <a:p>
            <a:pPr marL="21590" algn="l" rtl="0" eaLnBrk="0">
              <a:lnSpc>
                <a:spcPct val="10700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 analyzed: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40105</a:t>
            </a:r>
            <a:r>
              <a:rPr sz="900" u="sng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900" u="sng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1.fcs      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-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Jan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-2024</a:t>
            </a:r>
            <a:endParaRPr lang="en-US" altLang="en-US" sz="900" dirty="0"/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lang="en-US" altLang="en-US" sz="900" dirty="0"/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lang="en-US" altLang="en-US" sz="1000" dirty="0"/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lang="en-US" altLang="en-US" sz="1000" dirty="0"/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lang="en-US" altLang="en-US" sz="900" dirty="0"/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900" dirty="0"/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0.32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3.05</a:t>
            </a:r>
            <a:endParaRPr lang="en-US" altLang="en-US" sz="900" dirty="0"/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.56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3.91</a:t>
            </a:r>
            <a:endParaRPr lang="en-US" altLang="en-US" sz="900" dirty="0"/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/G1:</a:t>
            </a:r>
            <a:r>
              <a:rPr sz="900" kern="0" spc="1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7</a:t>
            </a:r>
            <a:endParaRPr lang="en-US" altLang="en-US" sz="900" dirty="0"/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.58</a:t>
            </a:r>
            <a:endParaRPr lang="en-US" altLang="en-US" sz="1000" dirty="0"/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se:</a:t>
            </a:r>
            <a:r>
              <a:rPr sz="900" kern="0" spc="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900" dirty="0"/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lang="en-US" altLang="en-US" sz="900" dirty="0"/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1000" dirty="0"/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1000" dirty="0"/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213</a:t>
            </a:r>
            <a:endParaRPr lang="en-US" altLang="en-US" sz="900" dirty="0"/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213</a:t>
            </a:r>
            <a:endParaRPr lang="en-US" altLang="en-US" sz="1000" dirty="0"/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93</a:t>
            </a:r>
            <a:endParaRPr lang="en-US" altLang="en-US" sz="900" dirty="0"/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-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65</a:t>
            </a:r>
            <a:endParaRPr lang="en-US" altLang="en-US" sz="900" dirty="0"/>
          </a:p>
        </p:txBody>
      </p:sp>
      <p:pic>
        <p:nvPicPr>
          <p:cNvPr id="26" name="picture 2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pic>
        <p:nvPicPr>
          <p:cNvPr id="28" name="picture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pic>
        <p:nvPicPr>
          <p:cNvPr id="30" name="picture 3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sp>
        <p:nvSpPr>
          <p:cNvPr id="32" name="textbox 32"/>
          <p:cNvSpPr/>
          <p:nvPr/>
        </p:nvSpPr>
        <p:spPr>
          <a:xfrm>
            <a:off x="882499" y="4078020"/>
            <a:ext cx="3767454" cy="30352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lang="en-US" altLang="en-US" sz="900" dirty="0"/>
          </a:p>
          <a:p>
            <a:pPr algn="l" rtl="0" eaLnBrk="0">
              <a:lnSpc>
                <a:spcPct val="105000"/>
              </a:lnSpc>
            </a:pPr>
            <a:endParaRPr lang="en-US" altLang="en-US" sz="300" dirty="0"/>
          </a:p>
          <a:p>
            <a:pPr marL="1741170" algn="l" rtl="0" eaLnBrk="0">
              <a:lnSpc>
                <a:spcPct val="78000"/>
              </a:lnSpc>
              <a:spcBef>
                <a:spcPts val="0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lang="en-US" altLang="en-US" sz="1000" dirty="0"/>
          </a:p>
        </p:txBody>
      </p:sp>
      <p:sp>
        <p:nvSpPr>
          <p:cNvPr id="34" name="path"/>
          <p:cNvSpPr/>
          <p:nvPr/>
        </p:nvSpPr>
        <p:spPr>
          <a:xfrm>
            <a:off x="3326689" y="7895413"/>
            <a:ext cx="765481" cy="701579"/>
          </a:xfrm>
          <a:custGeom>
            <a:avLst/>
            <a:gdLst/>
            <a:ahLst/>
            <a:cxnLst/>
            <a:rect l="0" t="0" r="0" b="0"/>
            <a:pathLst>
              <a:path w="1205" h="1104">
                <a:moveTo>
                  <a:pt x="1188" y="475"/>
                </a:moveTo>
                <a:lnTo>
                  <a:pt x="1144" y="560"/>
                </a:lnTo>
                <a:lnTo>
                  <a:pt x="1100" y="642"/>
                </a:lnTo>
                <a:moveTo>
                  <a:pt x="730" y="959"/>
                </a:moveTo>
                <a:lnTo>
                  <a:pt x="646" y="993"/>
                </a:lnTo>
                <a:lnTo>
                  <a:pt x="558" y="1028"/>
                </a:lnTo>
                <a:lnTo>
                  <a:pt x="474" y="1053"/>
                </a:lnTo>
                <a:lnTo>
                  <a:pt x="391" y="1075"/>
                </a:lnTo>
                <a:lnTo>
                  <a:pt x="303" y="1088"/>
                </a:lnTo>
                <a:moveTo>
                  <a:pt x="60" y="963"/>
                </a:moveTo>
                <a:lnTo>
                  <a:pt x="30" y="882"/>
                </a:lnTo>
                <a:lnTo>
                  <a:pt x="16" y="800"/>
                </a:lnTo>
                <a:lnTo>
                  <a:pt x="21" y="723"/>
                </a:lnTo>
                <a:lnTo>
                  <a:pt x="38" y="650"/>
                </a:lnTo>
                <a:moveTo>
                  <a:pt x="74" y="586"/>
                </a:moveTo>
                <a:lnTo>
                  <a:pt x="118" y="505"/>
                </a:lnTo>
                <a:moveTo>
                  <a:pt x="228" y="372"/>
                </a:moveTo>
                <a:lnTo>
                  <a:pt x="303" y="312"/>
                </a:lnTo>
                <a:moveTo>
                  <a:pt x="430" y="218"/>
                </a:moveTo>
                <a:lnTo>
                  <a:pt x="510" y="171"/>
                </a:lnTo>
                <a:moveTo>
                  <a:pt x="580" y="128"/>
                </a:moveTo>
                <a:lnTo>
                  <a:pt x="673" y="85"/>
                </a:lnTo>
                <a:moveTo>
                  <a:pt x="743" y="55"/>
                </a:moveTo>
                <a:lnTo>
                  <a:pt x="823" y="33"/>
                </a:lnTo>
                <a:lnTo>
                  <a:pt x="897" y="16"/>
                </a:lnTo>
                <a:moveTo>
                  <a:pt x="972" y="16"/>
                </a:moveTo>
                <a:lnTo>
                  <a:pt x="1047" y="21"/>
                </a:lnTo>
                <a:lnTo>
                  <a:pt x="1122" y="33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6" name="path"/>
          <p:cNvSpPr/>
          <p:nvPr/>
        </p:nvSpPr>
        <p:spPr>
          <a:xfrm>
            <a:off x="5730380" y="7947108"/>
            <a:ext cx="745900" cy="636279"/>
          </a:xfrm>
          <a:custGeom>
            <a:avLst/>
            <a:gdLst/>
            <a:ahLst/>
            <a:cxnLst/>
            <a:rect l="0" t="0" r="0" b="0"/>
            <a:pathLst>
              <a:path w="1174" h="1002">
                <a:moveTo>
                  <a:pt x="1007" y="51"/>
                </a:moveTo>
                <a:lnTo>
                  <a:pt x="1052" y="112"/>
                </a:lnTo>
                <a:lnTo>
                  <a:pt x="1093" y="182"/>
                </a:lnTo>
                <a:lnTo>
                  <a:pt x="1121" y="265"/>
                </a:lnTo>
                <a:lnTo>
                  <a:pt x="1139" y="339"/>
                </a:lnTo>
                <a:lnTo>
                  <a:pt x="1157" y="409"/>
                </a:lnTo>
                <a:lnTo>
                  <a:pt x="1157" y="448"/>
                </a:lnTo>
                <a:lnTo>
                  <a:pt x="1157" y="487"/>
                </a:lnTo>
                <a:lnTo>
                  <a:pt x="1144" y="570"/>
                </a:lnTo>
                <a:lnTo>
                  <a:pt x="1103" y="644"/>
                </a:lnTo>
                <a:lnTo>
                  <a:pt x="1048" y="723"/>
                </a:lnTo>
                <a:lnTo>
                  <a:pt x="979" y="788"/>
                </a:lnTo>
                <a:lnTo>
                  <a:pt x="915" y="836"/>
                </a:lnTo>
                <a:lnTo>
                  <a:pt x="842" y="880"/>
                </a:lnTo>
                <a:lnTo>
                  <a:pt x="779" y="915"/>
                </a:lnTo>
                <a:lnTo>
                  <a:pt x="692" y="941"/>
                </a:lnTo>
                <a:lnTo>
                  <a:pt x="605" y="963"/>
                </a:lnTo>
                <a:lnTo>
                  <a:pt x="518" y="980"/>
                </a:lnTo>
                <a:lnTo>
                  <a:pt x="436" y="985"/>
                </a:lnTo>
                <a:lnTo>
                  <a:pt x="359" y="985"/>
                </a:lnTo>
                <a:lnTo>
                  <a:pt x="286" y="972"/>
                </a:lnTo>
                <a:lnTo>
                  <a:pt x="208" y="954"/>
                </a:lnTo>
                <a:lnTo>
                  <a:pt x="130" y="915"/>
                </a:lnTo>
                <a:lnTo>
                  <a:pt x="80" y="858"/>
                </a:lnTo>
                <a:lnTo>
                  <a:pt x="44" y="788"/>
                </a:lnTo>
                <a:lnTo>
                  <a:pt x="21" y="714"/>
                </a:lnTo>
                <a:lnTo>
                  <a:pt x="16" y="636"/>
                </a:lnTo>
                <a:lnTo>
                  <a:pt x="16" y="596"/>
                </a:lnTo>
                <a:lnTo>
                  <a:pt x="16" y="557"/>
                </a:lnTo>
                <a:lnTo>
                  <a:pt x="53" y="496"/>
                </a:lnTo>
                <a:lnTo>
                  <a:pt x="98" y="422"/>
                </a:lnTo>
                <a:lnTo>
                  <a:pt x="158" y="352"/>
                </a:lnTo>
                <a:lnTo>
                  <a:pt x="222" y="291"/>
                </a:lnTo>
                <a:lnTo>
                  <a:pt x="272" y="239"/>
                </a:lnTo>
                <a:lnTo>
                  <a:pt x="336" y="186"/>
                </a:lnTo>
                <a:lnTo>
                  <a:pt x="404" y="138"/>
                </a:lnTo>
                <a:lnTo>
                  <a:pt x="477" y="90"/>
                </a:lnTo>
                <a:lnTo>
                  <a:pt x="541" y="56"/>
                </a:lnTo>
                <a:lnTo>
                  <a:pt x="614" y="29"/>
                </a:lnTo>
                <a:lnTo>
                  <a:pt x="687" y="16"/>
                </a:lnTo>
                <a:lnTo>
                  <a:pt x="701" y="16"/>
                </a:lnTo>
                <a:lnTo>
                  <a:pt x="777" y="25"/>
                </a:lnTo>
                <a:lnTo>
                  <a:pt x="854" y="34"/>
                </a:lnTo>
                <a:lnTo>
                  <a:pt x="930" y="42"/>
                </a:lnTo>
                <a:lnTo>
                  <a:pt x="1007" y="51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8" name="path"/>
          <p:cNvSpPr/>
          <p:nvPr/>
        </p:nvSpPr>
        <p:spPr>
          <a:xfrm>
            <a:off x="1009718" y="8039617"/>
            <a:ext cx="852201" cy="394125"/>
          </a:xfrm>
          <a:custGeom>
            <a:avLst/>
            <a:gdLst/>
            <a:ahLst/>
            <a:cxnLst/>
            <a:rect l="0" t="0" r="0" b="0"/>
            <a:pathLst>
              <a:path w="1342" h="620">
                <a:moveTo>
                  <a:pt x="563" y="16"/>
                </a:moveTo>
                <a:lnTo>
                  <a:pt x="633" y="16"/>
                </a:lnTo>
                <a:lnTo>
                  <a:pt x="717" y="16"/>
                </a:lnTo>
                <a:lnTo>
                  <a:pt x="774" y="18"/>
                </a:lnTo>
                <a:lnTo>
                  <a:pt x="831" y="21"/>
                </a:lnTo>
                <a:lnTo>
                  <a:pt x="889" y="29"/>
                </a:lnTo>
                <a:lnTo>
                  <a:pt x="946" y="38"/>
                </a:lnTo>
                <a:lnTo>
                  <a:pt x="1038" y="51"/>
                </a:lnTo>
                <a:lnTo>
                  <a:pt x="1131" y="68"/>
                </a:lnTo>
                <a:lnTo>
                  <a:pt x="1206" y="93"/>
                </a:lnTo>
                <a:lnTo>
                  <a:pt x="1276" y="132"/>
                </a:lnTo>
                <a:lnTo>
                  <a:pt x="1316" y="192"/>
                </a:lnTo>
                <a:lnTo>
                  <a:pt x="1325" y="261"/>
                </a:lnTo>
                <a:lnTo>
                  <a:pt x="1289" y="333"/>
                </a:lnTo>
                <a:lnTo>
                  <a:pt x="1232" y="381"/>
                </a:lnTo>
                <a:lnTo>
                  <a:pt x="1171" y="419"/>
                </a:lnTo>
                <a:lnTo>
                  <a:pt x="1109" y="453"/>
                </a:lnTo>
                <a:lnTo>
                  <a:pt x="1043" y="479"/>
                </a:lnTo>
                <a:lnTo>
                  <a:pt x="992" y="494"/>
                </a:lnTo>
                <a:lnTo>
                  <a:pt x="941" y="509"/>
                </a:lnTo>
                <a:lnTo>
                  <a:pt x="871" y="526"/>
                </a:lnTo>
                <a:lnTo>
                  <a:pt x="800" y="543"/>
                </a:lnTo>
                <a:lnTo>
                  <a:pt x="730" y="552"/>
                </a:lnTo>
                <a:lnTo>
                  <a:pt x="660" y="565"/>
                </a:lnTo>
                <a:lnTo>
                  <a:pt x="567" y="586"/>
                </a:lnTo>
                <a:lnTo>
                  <a:pt x="483" y="599"/>
                </a:lnTo>
                <a:lnTo>
                  <a:pt x="395" y="603"/>
                </a:lnTo>
                <a:lnTo>
                  <a:pt x="320" y="603"/>
                </a:lnTo>
                <a:lnTo>
                  <a:pt x="232" y="573"/>
                </a:lnTo>
                <a:lnTo>
                  <a:pt x="166" y="543"/>
                </a:lnTo>
                <a:lnTo>
                  <a:pt x="100" y="518"/>
                </a:lnTo>
                <a:lnTo>
                  <a:pt x="38" y="471"/>
                </a:lnTo>
                <a:lnTo>
                  <a:pt x="21" y="398"/>
                </a:lnTo>
                <a:lnTo>
                  <a:pt x="16" y="325"/>
                </a:lnTo>
                <a:lnTo>
                  <a:pt x="56" y="248"/>
                </a:lnTo>
                <a:lnTo>
                  <a:pt x="104" y="183"/>
                </a:lnTo>
                <a:lnTo>
                  <a:pt x="153" y="123"/>
                </a:lnTo>
                <a:lnTo>
                  <a:pt x="201" y="93"/>
                </a:lnTo>
                <a:lnTo>
                  <a:pt x="274" y="78"/>
                </a:lnTo>
                <a:lnTo>
                  <a:pt x="346" y="63"/>
                </a:lnTo>
                <a:lnTo>
                  <a:pt x="418" y="47"/>
                </a:lnTo>
                <a:lnTo>
                  <a:pt x="490" y="32"/>
                </a:lnTo>
                <a:lnTo>
                  <a:pt x="563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0" name="textbox 40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48000"/>
              </a:lnSpc>
            </a:pPr>
            <a:endParaRPr lang="en-US" altLang="en-US" sz="200" dirty="0"/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lang="en-US" altLang="en-US" sz="1000" dirty="0"/>
          </a:p>
        </p:txBody>
      </p:sp>
      <p:sp>
        <p:nvSpPr>
          <p:cNvPr id="42" name="textbox 42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48000"/>
              </a:lnSpc>
            </a:pPr>
            <a:endParaRPr lang="en-US" altLang="en-US" sz="200" dirty="0"/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lang="en-US" altLang="en-US" sz="1000" dirty="0"/>
          </a:p>
        </p:txBody>
      </p:sp>
      <p:sp>
        <p:nvSpPr>
          <p:cNvPr id="44" name="textbox 44"/>
          <p:cNvSpPr/>
          <p:nvPr/>
        </p:nvSpPr>
        <p:spPr>
          <a:xfrm>
            <a:off x="5519459" y="8760429"/>
            <a:ext cx="1303019" cy="28765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02000"/>
              </a:lnSpc>
            </a:pPr>
            <a:endParaRPr lang="en-US" altLang="en-US" sz="300" dirty="0"/>
          </a:p>
          <a:p>
            <a:pPr marL="537845" algn="l" rtl="0" eaLnBrk="0">
              <a:lnSpc>
                <a:spcPct val="78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lang="en-US" altLang="en-US" sz="1000" dirty="0"/>
          </a:p>
        </p:txBody>
      </p:sp>
      <p:sp>
        <p:nvSpPr>
          <p:cNvPr id="46" name="textbox 46"/>
          <p:cNvSpPr/>
          <p:nvPr/>
        </p:nvSpPr>
        <p:spPr>
          <a:xfrm rot="16200000">
            <a:off x="-777778" y="2388729"/>
            <a:ext cx="2940685" cy="16256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lang="en-US" altLang="en-US" sz="200" dirty="0"/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             1000              2000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3000              4000</a:t>
            </a:r>
            <a:endParaRPr lang="en-US" altLang="en-US" sz="900" dirty="0"/>
          </a:p>
        </p:txBody>
      </p:sp>
      <p:sp>
        <p:nvSpPr>
          <p:cNvPr id="48" name="path"/>
          <p:cNvSpPr/>
          <p:nvPr/>
        </p:nvSpPr>
        <p:spPr>
          <a:xfrm>
            <a:off x="787161" y="3209198"/>
            <a:ext cx="135349" cy="562767"/>
          </a:xfrm>
          <a:custGeom>
            <a:avLst/>
            <a:gdLst/>
            <a:ahLst/>
            <a:cxnLst/>
            <a:rect l="0" t="0" r="0" b="0"/>
            <a:pathLst>
              <a:path w="213" h="886">
                <a:moveTo>
                  <a:pt x="207" y="880"/>
                </a:moveTo>
                <a:lnTo>
                  <a:pt x="106" y="880"/>
                </a:lnTo>
                <a:moveTo>
                  <a:pt x="207" y="656"/>
                </a:moveTo>
                <a:lnTo>
                  <a:pt x="106" y="656"/>
                </a:lnTo>
                <a:moveTo>
                  <a:pt x="207" y="443"/>
                </a:moveTo>
                <a:lnTo>
                  <a:pt x="106" y="443"/>
                </a:lnTo>
                <a:moveTo>
                  <a:pt x="207" y="218"/>
                </a:moveTo>
                <a:lnTo>
                  <a:pt x="106" y="218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0" name="path"/>
          <p:cNvSpPr/>
          <p:nvPr/>
        </p:nvSpPr>
        <p:spPr>
          <a:xfrm>
            <a:off x="787161" y="1136219"/>
            <a:ext cx="135349" cy="555644"/>
          </a:xfrm>
          <a:custGeom>
            <a:avLst/>
            <a:gdLst/>
            <a:ahLst/>
            <a:cxnLst/>
            <a:rect l="0" t="0" r="0" b="0"/>
            <a:pathLst>
              <a:path w="213" h="875">
                <a:moveTo>
                  <a:pt x="207" y="869"/>
                </a:moveTo>
                <a:lnTo>
                  <a:pt x="106" y="869"/>
                </a:lnTo>
                <a:moveTo>
                  <a:pt x="207" y="656"/>
                </a:moveTo>
                <a:lnTo>
                  <a:pt x="106" y="656"/>
                </a:lnTo>
                <a:moveTo>
                  <a:pt x="207" y="431"/>
                </a:moveTo>
                <a:lnTo>
                  <a:pt x="106" y="431"/>
                </a:lnTo>
                <a:moveTo>
                  <a:pt x="207" y="218"/>
                </a:moveTo>
                <a:lnTo>
                  <a:pt x="106" y="218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2" name="path"/>
          <p:cNvSpPr/>
          <p:nvPr/>
        </p:nvSpPr>
        <p:spPr>
          <a:xfrm>
            <a:off x="787161" y="1827213"/>
            <a:ext cx="135349" cy="555643"/>
          </a:xfrm>
          <a:custGeom>
            <a:avLst/>
            <a:gdLst/>
            <a:ahLst/>
            <a:cxnLst/>
            <a:rect l="0" t="0" r="0" b="0"/>
            <a:pathLst>
              <a:path w="213" h="875">
                <a:moveTo>
                  <a:pt x="207" y="869"/>
                </a:moveTo>
                <a:lnTo>
                  <a:pt x="106" y="869"/>
                </a:lnTo>
                <a:moveTo>
                  <a:pt x="207" y="656"/>
                </a:moveTo>
                <a:lnTo>
                  <a:pt x="106" y="656"/>
                </a:lnTo>
                <a:moveTo>
                  <a:pt x="207" y="443"/>
                </a:moveTo>
                <a:lnTo>
                  <a:pt x="106" y="443"/>
                </a:lnTo>
                <a:moveTo>
                  <a:pt x="207" y="218"/>
                </a:moveTo>
                <a:lnTo>
                  <a:pt x="106" y="218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4" name="path"/>
          <p:cNvSpPr/>
          <p:nvPr/>
        </p:nvSpPr>
        <p:spPr>
          <a:xfrm>
            <a:off x="787161" y="3900191"/>
            <a:ext cx="135349" cy="7123"/>
          </a:xfrm>
          <a:custGeom>
            <a:avLst/>
            <a:gdLst/>
            <a:ahLst/>
            <a:cxnLst/>
            <a:rect l="0" t="0" r="0" b="0"/>
            <a:pathLst>
              <a:path w="213" h="11"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6" name="path"/>
          <p:cNvSpPr/>
          <p:nvPr/>
        </p:nvSpPr>
        <p:spPr>
          <a:xfrm>
            <a:off x="787161" y="2518205"/>
            <a:ext cx="135349" cy="555643"/>
          </a:xfrm>
          <a:custGeom>
            <a:avLst/>
            <a:gdLst/>
            <a:ahLst/>
            <a:cxnLst/>
            <a:rect l="0" t="0" r="0" b="0"/>
            <a:pathLst>
              <a:path w="213" h="875">
                <a:moveTo>
                  <a:pt x="207" y="869"/>
                </a:moveTo>
                <a:lnTo>
                  <a:pt x="106" y="869"/>
                </a:lnTo>
                <a:moveTo>
                  <a:pt x="207" y="656"/>
                </a:moveTo>
                <a:lnTo>
                  <a:pt x="106" y="656"/>
                </a:lnTo>
                <a:moveTo>
                  <a:pt x="207" y="443"/>
                </a:moveTo>
                <a:lnTo>
                  <a:pt x="106" y="443"/>
                </a:lnTo>
                <a:moveTo>
                  <a:pt x="207" y="218"/>
                </a:moveTo>
                <a:lnTo>
                  <a:pt x="106" y="218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8" name="path"/>
          <p:cNvSpPr/>
          <p:nvPr/>
        </p:nvSpPr>
        <p:spPr>
          <a:xfrm>
            <a:off x="851274" y="787162"/>
            <a:ext cx="71236" cy="3120152"/>
          </a:xfrm>
          <a:custGeom>
            <a:avLst/>
            <a:gdLst/>
            <a:ahLst/>
            <a:cxnLst/>
            <a:rect l="0" t="0" r="0" b="0"/>
            <a:pathLst>
              <a:path w="112" h="4913">
                <a:moveTo>
                  <a:pt x="106" y="330"/>
                </a:moveTo>
                <a:lnTo>
                  <a:pt x="5" y="330"/>
                </a:lnTo>
                <a:moveTo>
                  <a:pt x="106" y="117"/>
                </a:moveTo>
                <a:lnTo>
                  <a:pt x="5" y="117"/>
                </a:lnTo>
                <a:moveTo>
                  <a:pt x="106" y="4908"/>
                </a:moveTo>
                <a:lnTo>
                  <a:pt x="10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0" name="path"/>
          <p:cNvSpPr/>
          <p:nvPr/>
        </p:nvSpPr>
        <p:spPr>
          <a:xfrm>
            <a:off x="3340676" y="7966154"/>
            <a:ext cx="365452" cy="353312"/>
          </a:xfrm>
          <a:custGeom>
            <a:avLst/>
            <a:gdLst/>
            <a:ahLst/>
            <a:cxnLst/>
            <a:rect l="0" t="0" r="0" b="0"/>
            <a:pathLst>
              <a:path w="575" h="556">
                <a:moveTo>
                  <a:pt x="16" y="539"/>
                </a:moveTo>
                <a:lnTo>
                  <a:pt x="52" y="475"/>
                </a:lnTo>
                <a:moveTo>
                  <a:pt x="96" y="393"/>
                </a:moveTo>
                <a:lnTo>
                  <a:pt x="144" y="325"/>
                </a:lnTo>
                <a:lnTo>
                  <a:pt x="206" y="261"/>
                </a:lnTo>
                <a:moveTo>
                  <a:pt x="281" y="201"/>
                </a:moveTo>
                <a:lnTo>
                  <a:pt x="347" y="153"/>
                </a:lnTo>
                <a:lnTo>
                  <a:pt x="408" y="106"/>
                </a:lnTo>
                <a:moveTo>
                  <a:pt x="488" y="59"/>
                </a:moveTo>
                <a:lnTo>
                  <a:pt x="558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textbox 62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lang="en-US" altLang="en-US" sz="800" dirty="0"/>
          </a:p>
        </p:txBody>
      </p:sp>
      <p:sp>
        <p:nvSpPr>
          <p:cNvPr id="64" name="textbox 64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66" name="textbox 66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68" name="textbox 68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70" name="path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path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6" name="path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8" name="path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0" name="path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2" name="path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4" name="path"/>
          <p:cNvSpPr/>
          <p:nvPr/>
        </p:nvSpPr>
        <p:spPr>
          <a:xfrm>
            <a:off x="32590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6" name="path"/>
          <p:cNvSpPr/>
          <p:nvPr/>
        </p:nvSpPr>
        <p:spPr>
          <a:xfrm>
            <a:off x="34514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8" name="path"/>
          <p:cNvSpPr/>
          <p:nvPr/>
        </p:nvSpPr>
        <p:spPr>
          <a:xfrm>
            <a:off x="36508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"/>
          <p:cNvSpPr/>
          <p:nvPr/>
        </p:nvSpPr>
        <p:spPr>
          <a:xfrm>
            <a:off x="4042664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path"/>
          <p:cNvSpPr/>
          <p:nvPr/>
        </p:nvSpPr>
        <p:spPr>
          <a:xfrm>
            <a:off x="42350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path"/>
          <p:cNvSpPr/>
          <p:nvPr/>
        </p:nvSpPr>
        <p:spPr>
          <a:xfrm>
            <a:off x="38432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path"/>
          <p:cNvSpPr/>
          <p:nvPr/>
        </p:nvSpPr>
        <p:spPr>
          <a:xfrm>
            <a:off x="3209198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path"/>
          <p:cNvSpPr/>
          <p:nvPr/>
        </p:nvSpPr>
        <p:spPr>
          <a:xfrm>
            <a:off x="5595616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0" name="path"/>
          <p:cNvSpPr/>
          <p:nvPr/>
        </p:nvSpPr>
        <p:spPr>
          <a:xfrm>
            <a:off x="5787955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2" name="path"/>
          <p:cNvSpPr/>
          <p:nvPr/>
        </p:nvSpPr>
        <p:spPr>
          <a:xfrm>
            <a:off x="5987417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4" name="path"/>
          <p:cNvSpPr/>
          <p:nvPr/>
        </p:nvSpPr>
        <p:spPr>
          <a:xfrm>
            <a:off x="6571555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path"/>
          <p:cNvSpPr/>
          <p:nvPr/>
        </p:nvSpPr>
        <p:spPr>
          <a:xfrm>
            <a:off x="6179754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path"/>
          <p:cNvSpPr/>
          <p:nvPr/>
        </p:nvSpPr>
        <p:spPr>
          <a:xfrm>
            <a:off x="6379216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0" name="path"/>
          <p:cNvSpPr/>
          <p:nvPr/>
        </p:nvSpPr>
        <p:spPr>
          <a:xfrm>
            <a:off x="5545751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2" name="path"/>
          <p:cNvSpPr/>
          <p:nvPr/>
        </p:nvSpPr>
        <p:spPr>
          <a:xfrm>
            <a:off x="758667" y="8053271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4" name="path"/>
          <p:cNvSpPr/>
          <p:nvPr/>
        </p:nvSpPr>
        <p:spPr>
          <a:xfrm>
            <a:off x="758667" y="8238486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6" name="path"/>
          <p:cNvSpPr/>
          <p:nvPr/>
        </p:nvSpPr>
        <p:spPr>
          <a:xfrm>
            <a:off x="758667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8" name="path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0" name="path"/>
          <p:cNvSpPr/>
          <p:nvPr/>
        </p:nvSpPr>
        <p:spPr>
          <a:xfrm>
            <a:off x="758667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2" name="path"/>
          <p:cNvSpPr/>
          <p:nvPr/>
        </p:nvSpPr>
        <p:spPr>
          <a:xfrm>
            <a:off x="758667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4" name="path"/>
          <p:cNvSpPr/>
          <p:nvPr/>
        </p:nvSpPr>
        <p:spPr>
          <a:xfrm>
            <a:off x="758667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6" name="path"/>
          <p:cNvSpPr/>
          <p:nvPr/>
        </p:nvSpPr>
        <p:spPr>
          <a:xfrm>
            <a:off x="815656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8" name="path"/>
          <p:cNvSpPr/>
          <p:nvPr/>
        </p:nvSpPr>
        <p:spPr>
          <a:xfrm>
            <a:off x="5431773" y="8238486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0" name="path"/>
          <p:cNvSpPr/>
          <p:nvPr/>
        </p:nvSpPr>
        <p:spPr>
          <a:xfrm>
            <a:off x="5431773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2" name="path"/>
          <p:cNvSpPr/>
          <p:nvPr/>
        </p:nvSpPr>
        <p:spPr>
          <a:xfrm>
            <a:off x="5431773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4" name="path"/>
          <p:cNvSpPr/>
          <p:nvPr/>
        </p:nvSpPr>
        <p:spPr>
          <a:xfrm>
            <a:off x="5431773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6" name="path"/>
          <p:cNvSpPr/>
          <p:nvPr/>
        </p:nvSpPr>
        <p:spPr>
          <a:xfrm>
            <a:off x="5431773" y="8053271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8" name="path"/>
          <p:cNvSpPr/>
          <p:nvPr/>
        </p:nvSpPr>
        <p:spPr>
          <a:xfrm>
            <a:off x="5431773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0" name="path"/>
          <p:cNvSpPr/>
          <p:nvPr/>
        </p:nvSpPr>
        <p:spPr>
          <a:xfrm>
            <a:off x="5431773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2" name="path"/>
          <p:cNvSpPr/>
          <p:nvPr/>
        </p:nvSpPr>
        <p:spPr>
          <a:xfrm>
            <a:off x="5488762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4" name="textbox 144"/>
          <p:cNvSpPr/>
          <p:nvPr/>
        </p:nvSpPr>
        <p:spPr>
          <a:xfrm>
            <a:off x="3991524" y="454610"/>
            <a:ext cx="309245" cy="28638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lang="en-US" altLang="en-US" sz="100" dirty="0"/>
          </a:p>
          <a:p>
            <a:pPr marL="12700" algn="l" rtl="0" eaLnBrk="0">
              <a:lnSpc>
                <a:spcPct val="122000"/>
              </a:lnSpc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lang="en-US" altLang="en-US" sz="700" dirty="0"/>
          </a:p>
        </p:txBody>
      </p:sp>
      <p:sp>
        <p:nvSpPr>
          <p:cNvPr id="146" name="textbox 146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lang="en-US" altLang="en-US" sz="900" dirty="0"/>
          </a:p>
        </p:txBody>
      </p:sp>
      <p:sp>
        <p:nvSpPr>
          <p:cNvPr id="148" name="path"/>
          <p:cNvSpPr/>
          <p:nvPr/>
        </p:nvSpPr>
        <p:spPr>
          <a:xfrm>
            <a:off x="3779869" y="8292655"/>
            <a:ext cx="256353" cy="222712"/>
          </a:xfrm>
          <a:custGeom>
            <a:avLst/>
            <a:gdLst/>
            <a:ahLst/>
            <a:cxnLst/>
            <a:rect l="0" t="0" r="0" b="0"/>
            <a:pathLst>
              <a:path w="403" h="350">
                <a:moveTo>
                  <a:pt x="386" y="16"/>
                </a:moveTo>
                <a:lnTo>
                  <a:pt x="338" y="85"/>
                </a:lnTo>
                <a:lnTo>
                  <a:pt x="281" y="149"/>
                </a:lnTo>
                <a:lnTo>
                  <a:pt x="215" y="209"/>
                </a:lnTo>
                <a:lnTo>
                  <a:pt x="148" y="261"/>
                </a:lnTo>
                <a:lnTo>
                  <a:pt x="82" y="303"/>
                </a:lnTo>
                <a:lnTo>
                  <a:pt x="16" y="333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0" name="textbox 150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lang="en-US" altLang="en-US" sz="800" dirty="0"/>
          </a:p>
        </p:txBody>
      </p:sp>
      <p:pic>
        <p:nvPicPr>
          <p:cNvPr id="152" name="picture 15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154" name="path"/>
          <p:cNvSpPr/>
          <p:nvPr/>
        </p:nvSpPr>
        <p:spPr>
          <a:xfrm>
            <a:off x="3095220" y="7447762"/>
            <a:ext cx="121101" cy="420294"/>
          </a:xfrm>
          <a:custGeom>
            <a:avLst/>
            <a:gdLst/>
            <a:ahLst/>
            <a:cxnLst/>
            <a:rect l="0" t="0" r="0" b="0"/>
            <a:pathLst>
              <a:path w="190" h="661"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6" name="path"/>
          <p:cNvSpPr/>
          <p:nvPr/>
        </p:nvSpPr>
        <p:spPr>
          <a:xfrm>
            <a:off x="4028839" y="7906296"/>
            <a:ext cx="119279" cy="301616"/>
          </a:xfrm>
          <a:custGeom>
            <a:avLst/>
            <a:gdLst/>
            <a:ahLst/>
            <a:cxnLst/>
            <a:rect l="0" t="0" r="0" b="0"/>
            <a:pathLst>
              <a:path w="187" h="474">
                <a:moveTo>
                  <a:pt x="171" y="119"/>
                </a:moveTo>
                <a:lnTo>
                  <a:pt x="171" y="188"/>
                </a:lnTo>
                <a:lnTo>
                  <a:pt x="157" y="256"/>
                </a:lnTo>
                <a:lnTo>
                  <a:pt x="142" y="308"/>
                </a:lnTo>
                <a:lnTo>
                  <a:pt x="126" y="359"/>
                </a:lnTo>
                <a:lnTo>
                  <a:pt x="104" y="408"/>
                </a:lnTo>
                <a:lnTo>
                  <a:pt x="82" y="458"/>
                </a:lnTo>
                <a:moveTo>
                  <a:pt x="16" y="16"/>
                </a:moveTo>
                <a:lnTo>
                  <a:pt x="69" y="25"/>
                </a:lnTo>
                <a:lnTo>
                  <a:pt x="120" y="72"/>
                </a:lnTo>
                <a:lnTo>
                  <a:pt x="171" y="119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8" name="textbox 158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lang="en-US" altLang="en-US" sz="200" dirty="0"/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lang="en-US" altLang="en-US" sz="1000" dirty="0"/>
          </a:p>
        </p:txBody>
      </p:sp>
      <p:sp>
        <p:nvSpPr>
          <p:cNvPr id="160" name="textbox 160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lang="en-US" altLang="en-US" sz="200" dirty="0"/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lang="en-US" altLang="en-US" sz="1000" dirty="0"/>
          </a:p>
        </p:txBody>
      </p:sp>
      <p:pic>
        <p:nvPicPr>
          <p:cNvPr id="162" name="picture 16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477284"/>
            <a:ext cx="121101" cy="220832"/>
          </a:xfrm>
          <a:prstGeom prst="rect">
            <a:avLst/>
          </a:prstGeom>
        </p:spPr>
      </p:pic>
      <p:sp>
        <p:nvSpPr>
          <p:cNvPr id="164" name="textbox 164"/>
          <p:cNvSpPr/>
          <p:nvPr/>
        </p:nvSpPr>
        <p:spPr>
          <a:xfrm rot="16200000">
            <a:off x="5062046" y="7924598"/>
            <a:ext cx="259715" cy="16891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2000"/>
              </a:lnSpc>
            </a:pPr>
            <a:endParaRPr lang="en-US" altLang="en-US" sz="200" dirty="0"/>
          </a:p>
          <a:p>
            <a:pPr marL="12700" algn="l" rtl="0" eaLnBrk="0">
              <a:lnSpc>
                <a:spcPct val="84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lang="en-US" altLang="en-US" sz="900" dirty="0"/>
          </a:p>
        </p:txBody>
      </p:sp>
      <p:sp>
        <p:nvSpPr>
          <p:cNvPr id="166" name="rect"/>
          <p:cNvSpPr/>
          <p:nvPr/>
        </p:nvSpPr>
        <p:spPr>
          <a:xfrm>
            <a:off x="3382804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68" name="rect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0" name="rect"/>
          <p:cNvSpPr/>
          <p:nvPr/>
        </p:nvSpPr>
        <p:spPr>
          <a:xfrm>
            <a:off x="1050796" y="7538984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2" name="path"/>
          <p:cNvSpPr/>
          <p:nvPr/>
        </p:nvSpPr>
        <p:spPr>
          <a:xfrm>
            <a:off x="3354663" y="8496717"/>
            <a:ext cx="175228" cy="100275"/>
          </a:xfrm>
          <a:custGeom>
            <a:avLst/>
            <a:gdLst/>
            <a:ahLst/>
            <a:cxnLst/>
            <a:rect l="0" t="0" r="0" b="0"/>
            <a:pathLst>
              <a:path w="275" h="157">
                <a:moveTo>
                  <a:pt x="259" y="141"/>
                </a:moveTo>
                <a:lnTo>
                  <a:pt x="188" y="141"/>
                </a:lnTo>
                <a:lnTo>
                  <a:pt x="118" y="141"/>
                </a:lnTo>
                <a:lnTo>
                  <a:pt x="52" y="81"/>
                </a:lnTo>
                <a:lnTo>
                  <a:pt x="16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4" name="path"/>
          <p:cNvSpPr/>
          <p:nvPr/>
        </p:nvSpPr>
        <p:spPr>
          <a:xfrm>
            <a:off x="3095220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6" name="path"/>
          <p:cNvSpPr/>
          <p:nvPr/>
        </p:nvSpPr>
        <p:spPr>
          <a:xfrm>
            <a:off x="3095220" y="8053271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8" name="path"/>
          <p:cNvSpPr/>
          <p:nvPr/>
        </p:nvSpPr>
        <p:spPr>
          <a:xfrm>
            <a:off x="3095220" y="8238486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0" name="textbox 180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lang="en-US" altLang="en-US" sz="1000" dirty="0"/>
          </a:p>
        </p:txBody>
      </p:sp>
      <p:sp>
        <p:nvSpPr>
          <p:cNvPr id="182" name="textbox 182"/>
          <p:cNvSpPr/>
          <p:nvPr/>
        </p:nvSpPr>
        <p:spPr>
          <a:xfrm>
            <a:off x="3379499" y="7540575"/>
            <a:ext cx="161289" cy="14477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lang="en-US" altLang="en-US" sz="1000" dirty="0"/>
          </a:p>
        </p:txBody>
      </p:sp>
      <p:sp>
        <p:nvSpPr>
          <p:cNvPr id="184" name="textbox 184"/>
          <p:cNvSpPr/>
          <p:nvPr/>
        </p:nvSpPr>
        <p:spPr>
          <a:xfrm>
            <a:off x="1047510" y="7544693"/>
            <a:ext cx="161289" cy="14477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lang="en-US" altLang="en-US" sz="1000" dirty="0"/>
          </a:p>
        </p:txBody>
      </p:sp>
      <p:sp>
        <p:nvSpPr>
          <p:cNvPr id="186" name="path"/>
          <p:cNvSpPr/>
          <p:nvPr/>
        </p:nvSpPr>
        <p:spPr>
          <a:xfrm>
            <a:off x="3095220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8" name="path"/>
          <p:cNvSpPr/>
          <p:nvPr/>
        </p:nvSpPr>
        <p:spPr>
          <a:xfrm>
            <a:off x="3152209" y="7910799"/>
            <a:ext cx="64112" cy="99730"/>
          </a:xfrm>
          <a:custGeom>
            <a:avLst/>
            <a:gdLst/>
            <a:ahLst/>
            <a:cxnLst/>
            <a:rect l="0" t="0" r="0" b="0"/>
            <a:pathLst>
              <a:path w="100" h="157">
                <a:moveTo>
                  <a:pt x="95" y="151"/>
                </a:moveTo>
                <a:lnTo>
                  <a:pt x="5" y="151"/>
                </a:lnTo>
                <a:moveTo>
                  <a:pt x="95" y="84"/>
                </a:moveTo>
                <a:lnTo>
                  <a:pt x="5" y="84"/>
                </a:lnTo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0" name="path"/>
          <p:cNvSpPr/>
          <p:nvPr/>
        </p:nvSpPr>
        <p:spPr>
          <a:xfrm>
            <a:off x="3209198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2" name="rect"/>
          <p:cNvSpPr/>
          <p:nvPr/>
        </p:nvSpPr>
        <p:spPr>
          <a:xfrm>
            <a:off x="3743503" y="7919901"/>
            <a:ext cx="66129" cy="40416"/>
          </a:xfrm>
          <a:prstGeom prst="rect">
            <a:avLst/>
          </a:prstGeom>
          <a:solidFill>
            <a:srgbClr val="000000">
              <a:alpha val="100000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4" name="path"/>
          <p:cNvSpPr/>
          <p:nvPr/>
        </p:nvSpPr>
        <p:spPr>
          <a:xfrm>
            <a:off x="3886171" y="7895413"/>
            <a:ext cx="68926" cy="21370"/>
          </a:xfrm>
          <a:custGeom>
            <a:avLst/>
            <a:gdLst/>
            <a:ahLst/>
            <a:cxnLst/>
            <a:rect l="0" t="0" r="0" b="0"/>
            <a:pathLst>
              <a:path w="108" h="33">
                <a:moveTo>
                  <a:pt x="16" y="16"/>
                </a:moveTo>
                <a:lnTo>
                  <a:pt x="91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ath 2"/>
          <p:cNvSpPr/>
          <p:nvPr/>
        </p:nvSpPr>
        <p:spPr>
          <a:xfrm>
            <a:off x="2062255" y="820635"/>
            <a:ext cx="334312" cy="2889470"/>
          </a:xfrm>
          <a:custGeom>
            <a:avLst/>
            <a:gdLst/>
            <a:ahLst/>
            <a:cxnLst/>
            <a:rect l="0" t="0" r="0" b="0"/>
            <a:pathLst>
              <a:path w="526" h="4550">
                <a:moveTo>
                  <a:pt x="7" y="4543"/>
                </a:moveTo>
                <a:lnTo>
                  <a:pt x="35" y="4371"/>
                </a:lnTo>
                <a:lnTo>
                  <a:pt x="64" y="4086"/>
                </a:lnTo>
                <a:lnTo>
                  <a:pt x="92" y="3868"/>
                </a:lnTo>
                <a:lnTo>
                  <a:pt x="121" y="3607"/>
                </a:lnTo>
                <a:lnTo>
                  <a:pt x="149" y="3328"/>
                </a:lnTo>
                <a:lnTo>
                  <a:pt x="177" y="3070"/>
                </a:lnTo>
                <a:lnTo>
                  <a:pt x="206" y="2547"/>
                </a:lnTo>
                <a:lnTo>
                  <a:pt x="234" y="1773"/>
                </a:lnTo>
                <a:lnTo>
                  <a:pt x="263" y="1058"/>
                </a:lnTo>
                <a:lnTo>
                  <a:pt x="291" y="163"/>
                </a:lnTo>
                <a:lnTo>
                  <a:pt x="320" y="7"/>
                </a:lnTo>
                <a:lnTo>
                  <a:pt x="348" y="571"/>
                </a:lnTo>
                <a:lnTo>
                  <a:pt x="376" y="1600"/>
                </a:lnTo>
                <a:lnTo>
                  <a:pt x="405" y="2606"/>
                </a:lnTo>
                <a:lnTo>
                  <a:pt x="433" y="3436"/>
                </a:lnTo>
                <a:lnTo>
                  <a:pt x="462" y="3987"/>
                </a:lnTo>
                <a:lnTo>
                  <a:pt x="490" y="4378"/>
                </a:lnTo>
                <a:lnTo>
                  <a:pt x="519" y="4528"/>
                </a:lnTo>
              </a:path>
            </a:pathLst>
          </a:custGeom>
          <a:noFill/>
          <a:ln w="9260" cap="rnd">
            <a:solidFill>
              <a:srgbClr val="000000"/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4" name="picture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787161" y="3680139"/>
            <a:ext cx="3758357" cy="355400"/>
          </a:xfrm>
          <a:prstGeom prst="rect">
            <a:avLst/>
          </a:prstGeom>
        </p:spPr>
      </p:pic>
      <p:pic>
        <p:nvPicPr>
          <p:cNvPr id="6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929204" y="1262391"/>
            <a:ext cx="3611684" cy="2638757"/>
          </a:xfrm>
          <a:prstGeom prst="rect">
            <a:avLst/>
          </a:prstGeom>
        </p:spPr>
      </p:pic>
      <p:sp>
        <p:nvSpPr>
          <p:cNvPr id="8" name="textbox 8"/>
          <p:cNvSpPr/>
          <p:nvPr/>
        </p:nvSpPr>
        <p:spPr>
          <a:xfrm>
            <a:off x="4699128" y="1081169"/>
            <a:ext cx="2123439" cy="33089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7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200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31222</a:t>
            </a:r>
            <a:r>
              <a:rPr sz="900" u="sng" kern="0" spc="4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u="sng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900" u="sng" kern="0" spc="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1.fcs       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-Dec-20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9.53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2.89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.43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2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3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.04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5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9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.04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552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55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1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 406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0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.636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10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 rot="21600000">
            <a:off x="5431773" y="7426391"/>
            <a:ext cx="1353491" cy="1303625"/>
            <a:chOff x="0" y="0"/>
            <a:chExt cx="1353491" cy="1303625"/>
          </a:xfrm>
        </p:grpSpPr>
        <p:sp>
          <p:nvSpPr>
            <p:cNvPr id="12" name="path 12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4" name="path 14"/>
            <p:cNvSpPr/>
            <p:nvPr/>
          </p:nvSpPr>
          <p:spPr>
            <a:xfrm>
              <a:off x="334972" y="537042"/>
              <a:ext cx="729115" cy="598187"/>
            </a:xfrm>
            <a:custGeom>
              <a:avLst/>
              <a:gdLst/>
              <a:ahLst/>
              <a:cxnLst/>
              <a:rect l="0" t="0" r="0" b="0"/>
              <a:pathLst>
                <a:path w="1148" h="942">
                  <a:moveTo>
                    <a:pt x="928" y="21"/>
                  </a:moveTo>
                  <a:lnTo>
                    <a:pt x="986" y="72"/>
                  </a:lnTo>
                  <a:lnTo>
                    <a:pt x="1047" y="132"/>
                  </a:lnTo>
                  <a:lnTo>
                    <a:pt x="1091" y="213"/>
                  </a:lnTo>
                  <a:lnTo>
                    <a:pt x="1122" y="299"/>
                  </a:lnTo>
                  <a:lnTo>
                    <a:pt x="1131" y="372"/>
                  </a:lnTo>
                  <a:lnTo>
                    <a:pt x="1131" y="411"/>
                  </a:lnTo>
                  <a:lnTo>
                    <a:pt x="1131" y="449"/>
                  </a:lnTo>
                  <a:lnTo>
                    <a:pt x="1096" y="531"/>
                  </a:lnTo>
                  <a:lnTo>
                    <a:pt x="1052" y="590"/>
                  </a:lnTo>
                  <a:lnTo>
                    <a:pt x="999" y="642"/>
                  </a:lnTo>
                  <a:lnTo>
                    <a:pt x="941" y="702"/>
                  </a:lnTo>
                  <a:lnTo>
                    <a:pt x="880" y="758"/>
                  </a:lnTo>
                  <a:lnTo>
                    <a:pt x="823" y="805"/>
                  </a:lnTo>
                  <a:lnTo>
                    <a:pt x="765" y="848"/>
                  </a:lnTo>
                  <a:lnTo>
                    <a:pt x="704" y="886"/>
                  </a:lnTo>
                  <a:lnTo>
                    <a:pt x="629" y="908"/>
                  </a:lnTo>
                  <a:lnTo>
                    <a:pt x="554" y="920"/>
                  </a:lnTo>
                  <a:lnTo>
                    <a:pt x="474" y="925"/>
                  </a:lnTo>
                  <a:lnTo>
                    <a:pt x="400" y="925"/>
                  </a:lnTo>
                  <a:lnTo>
                    <a:pt x="329" y="916"/>
                  </a:lnTo>
                  <a:lnTo>
                    <a:pt x="259" y="895"/>
                  </a:lnTo>
                  <a:lnTo>
                    <a:pt x="193" y="860"/>
                  </a:lnTo>
                  <a:lnTo>
                    <a:pt x="140" y="813"/>
                  </a:lnTo>
                  <a:lnTo>
                    <a:pt x="78" y="766"/>
                  </a:lnTo>
                  <a:lnTo>
                    <a:pt x="30" y="706"/>
                  </a:lnTo>
                  <a:lnTo>
                    <a:pt x="16" y="638"/>
                  </a:lnTo>
                  <a:lnTo>
                    <a:pt x="21" y="569"/>
                  </a:lnTo>
                  <a:lnTo>
                    <a:pt x="43" y="501"/>
                  </a:lnTo>
                  <a:lnTo>
                    <a:pt x="69" y="436"/>
                  </a:lnTo>
                  <a:lnTo>
                    <a:pt x="100" y="372"/>
                  </a:lnTo>
                  <a:lnTo>
                    <a:pt x="144" y="312"/>
                  </a:lnTo>
                  <a:lnTo>
                    <a:pt x="201" y="248"/>
                  </a:lnTo>
                  <a:lnTo>
                    <a:pt x="259" y="205"/>
                  </a:lnTo>
                  <a:lnTo>
                    <a:pt x="316" y="162"/>
                  </a:lnTo>
                  <a:lnTo>
                    <a:pt x="382" y="132"/>
                  </a:lnTo>
                  <a:lnTo>
                    <a:pt x="452" y="98"/>
                  </a:lnTo>
                  <a:lnTo>
                    <a:pt x="519" y="68"/>
                  </a:lnTo>
                  <a:lnTo>
                    <a:pt x="589" y="42"/>
                  </a:lnTo>
                  <a:lnTo>
                    <a:pt x="660" y="21"/>
                  </a:lnTo>
                  <a:lnTo>
                    <a:pt x="673" y="16"/>
                  </a:lnTo>
                  <a:lnTo>
                    <a:pt x="737" y="17"/>
                  </a:lnTo>
                  <a:lnTo>
                    <a:pt x="800" y="18"/>
                  </a:lnTo>
                  <a:lnTo>
                    <a:pt x="864" y="20"/>
                  </a:lnTo>
                  <a:lnTo>
                    <a:pt x="928" y="21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16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 rot="21600000">
            <a:off x="3095220" y="7426391"/>
            <a:ext cx="1353491" cy="1303625"/>
            <a:chOff x="0" y="0"/>
            <a:chExt cx="1353491" cy="1303625"/>
          </a:xfrm>
        </p:grpSpPr>
        <p:sp>
          <p:nvSpPr>
            <p:cNvPr id="18" name="path 18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0" name="path 20"/>
            <p:cNvSpPr/>
            <p:nvPr/>
          </p:nvSpPr>
          <p:spPr>
            <a:xfrm>
              <a:off x="376856" y="634992"/>
              <a:ext cx="720723" cy="554654"/>
            </a:xfrm>
            <a:custGeom>
              <a:avLst/>
              <a:gdLst/>
              <a:ahLst/>
              <a:cxnLst/>
              <a:rect l="0" t="0" r="0" b="0"/>
              <a:pathLst>
                <a:path w="1134" h="873">
                  <a:moveTo>
                    <a:pt x="1082" y="76"/>
                  </a:moveTo>
                  <a:lnTo>
                    <a:pt x="1104" y="153"/>
                  </a:lnTo>
                  <a:lnTo>
                    <a:pt x="1118" y="222"/>
                  </a:lnTo>
                  <a:lnTo>
                    <a:pt x="1118" y="267"/>
                  </a:lnTo>
                  <a:lnTo>
                    <a:pt x="1118" y="312"/>
                  </a:lnTo>
                  <a:lnTo>
                    <a:pt x="1113" y="389"/>
                  </a:lnTo>
                  <a:lnTo>
                    <a:pt x="1087" y="483"/>
                  </a:lnTo>
                  <a:lnTo>
                    <a:pt x="1052" y="560"/>
                  </a:lnTo>
                  <a:lnTo>
                    <a:pt x="1012" y="625"/>
                  </a:lnTo>
                  <a:lnTo>
                    <a:pt x="959" y="676"/>
                  </a:lnTo>
                  <a:lnTo>
                    <a:pt x="906" y="723"/>
                  </a:lnTo>
                  <a:lnTo>
                    <a:pt x="840" y="766"/>
                  </a:lnTo>
                  <a:lnTo>
                    <a:pt x="778" y="800"/>
                  </a:lnTo>
                  <a:lnTo>
                    <a:pt x="699" y="830"/>
                  </a:lnTo>
                  <a:lnTo>
                    <a:pt x="615" y="843"/>
                  </a:lnTo>
                  <a:lnTo>
                    <a:pt x="545" y="852"/>
                  </a:lnTo>
                  <a:lnTo>
                    <a:pt x="474" y="852"/>
                  </a:lnTo>
                  <a:lnTo>
                    <a:pt x="400" y="856"/>
                  </a:lnTo>
                  <a:lnTo>
                    <a:pt x="325" y="856"/>
                  </a:lnTo>
                  <a:lnTo>
                    <a:pt x="254" y="856"/>
                  </a:lnTo>
                  <a:lnTo>
                    <a:pt x="175" y="830"/>
                  </a:lnTo>
                  <a:lnTo>
                    <a:pt x="104" y="800"/>
                  </a:lnTo>
                  <a:lnTo>
                    <a:pt x="47" y="749"/>
                  </a:lnTo>
                  <a:lnTo>
                    <a:pt x="21" y="668"/>
                  </a:lnTo>
                  <a:lnTo>
                    <a:pt x="16" y="595"/>
                  </a:lnTo>
                  <a:lnTo>
                    <a:pt x="16" y="558"/>
                  </a:lnTo>
                  <a:lnTo>
                    <a:pt x="16" y="522"/>
                  </a:lnTo>
                  <a:lnTo>
                    <a:pt x="38" y="453"/>
                  </a:lnTo>
                  <a:lnTo>
                    <a:pt x="82" y="381"/>
                  </a:lnTo>
                  <a:lnTo>
                    <a:pt x="126" y="312"/>
                  </a:lnTo>
                  <a:lnTo>
                    <a:pt x="171" y="256"/>
                  </a:lnTo>
                  <a:lnTo>
                    <a:pt x="223" y="205"/>
                  </a:lnTo>
                  <a:lnTo>
                    <a:pt x="294" y="145"/>
                  </a:lnTo>
                  <a:lnTo>
                    <a:pt x="360" y="102"/>
                  </a:lnTo>
                  <a:lnTo>
                    <a:pt x="426" y="68"/>
                  </a:lnTo>
                  <a:lnTo>
                    <a:pt x="492" y="38"/>
                  </a:lnTo>
                  <a:lnTo>
                    <a:pt x="580" y="21"/>
                  </a:lnTo>
                  <a:lnTo>
                    <a:pt x="660" y="16"/>
                  </a:lnTo>
                  <a:lnTo>
                    <a:pt x="730" y="16"/>
                  </a:lnTo>
                  <a:lnTo>
                    <a:pt x="805" y="21"/>
                  </a:lnTo>
                  <a:lnTo>
                    <a:pt x="831" y="25"/>
                  </a:lnTo>
                  <a:lnTo>
                    <a:pt x="894" y="38"/>
                  </a:lnTo>
                  <a:lnTo>
                    <a:pt x="957" y="51"/>
                  </a:lnTo>
                  <a:lnTo>
                    <a:pt x="1020" y="63"/>
                  </a:lnTo>
                  <a:lnTo>
                    <a:pt x="1082" y="76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22" name="picture 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sp>
        <p:nvSpPr>
          <p:cNvPr id="24" name="textbox 24"/>
          <p:cNvSpPr/>
          <p:nvPr/>
        </p:nvSpPr>
        <p:spPr>
          <a:xfrm>
            <a:off x="882499" y="4078020"/>
            <a:ext cx="3767454" cy="3124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741170" algn="l" rtl="0" eaLnBrk="0">
              <a:lnSpc>
                <a:spcPts val="1270"/>
              </a:lnSpc>
              <a:spcBef>
                <a:spcPts val="11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26" name="textbox 26"/>
          <p:cNvSpPr/>
          <p:nvPr/>
        </p:nvSpPr>
        <p:spPr>
          <a:xfrm>
            <a:off x="5519459" y="8760429"/>
            <a:ext cx="1303019" cy="32639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537210" indent="-525145" algn="l" rtl="0" eaLnBrk="0">
              <a:lnSpc>
                <a:spcPct val="116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 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80</a:t>
            </a:r>
            <a:r>
              <a:rPr sz="700" kern="0" spc="1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  120  </a:t>
            </a: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28" name="textbox 28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0" name="textbox 30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2" name="textbox 32"/>
          <p:cNvSpPr/>
          <p:nvPr/>
        </p:nvSpPr>
        <p:spPr>
          <a:xfrm rot="16200000">
            <a:off x="-952306" y="2214200"/>
            <a:ext cx="3289934" cy="16256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00</a:t>
            </a: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4" name="path 34"/>
          <p:cNvSpPr/>
          <p:nvPr/>
        </p:nvSpPr>
        <p:spPr>
          <a:xfrm>
            <a:off x="1166600" y="8053654"/>
            <a:ext cx="651294" cy="325403"/>
          </a:xfrm>
          <a:custGeom>
            <a:avLst/>
            <a:gdLst/>
            <a:ahLst/>
            <a:cxnLst/>
            <a:rect l="0" t="0" r="0" b="0"/>
            <a:pathLst>
              <a:path w="1025" h="512">
                <a:moveTo>
                  <a:pt x="663" y="35"/>
                </a:moveTo>
                <a:lnTo>
                  <a:pt x="732" y="25"/>
                </a:lnTo>
                <a:lnTo>
                  <a:pt x="822" y="16"/>
                </a:lnTo>
                <a:lnTo>
                  <a:pt x="902" y="20"/>
                </a:lnTo>
                <a:lnTo>
                  <a:pt x="964" y="42"/>
                </a:lnTo>
                <a:lnTo>
                  <a:pt x="995" y="96"/>
                </a:lnTo>
                <a:lnTo>
                  <a:pt x="1008" y="159"/>
                </a:lnTo>
                <a:lnTo>
                  <a:pt x="1006" y="225"/>
                </a:lnTo>
                <a:lnTo>
                  <a:pt x="962" y="281"/>
                </a:lnTo>
                <a:lnTo>
                  <a:pt x="904" y="320"/>
                </a:lnTo>
                <a:lnTo>
                  <a:pt x="849" y="350"/>
                </a:lnTo>
                <a:lnTo>
                  <a:pt x="782" y="375"/>
                </a:lnTo>
                <a:lnTo>
                  <a:pt x="709" y="397"/>
                </a:lnTo>
                <a:lnTo>
                  <a:pt x="626" y="420"/>
                </a:lnTo>
                <a:lnTo>
                  <a:pt x="557" y="441"/>
                </a:lnTo>
                <a:lnTo>
                  <a:pt x="493" y="458"/>
                </a:lnTo>
                <a:lnTo>
                  <a:pt x="432" y="474"/>
                </a:lnTo>
                <a:lnTo>
                  <a:pt x="366" y="484"/>
                </a:lnTo>
                <a:lnTo>
                  <a:pt x="296" y="493"/>
                </a:lnTo>
                <a:lnTo>
                  <a:pt x="229" y="495"/>
                </a:lnTo>
                <a:lnTo>
                  <a:pt x="160" y="486"/>
                </a:lnTo>
                <a:lnTo>
                  <a:pt x="99" y="471"/>
                </a:lnTo>
                <a:lnTo>
                  <a:pt x="49" y="424"/>
                </a:lnTo>
                <a:lnTo>
                  <a:pt x="21" y="367"/>
                </a:lnTo>
                <a:lnTo>
                  <a:pt x="16" y="306"/>
                </a:lnTo>
                <a:lnTo>
                  <a:pt x="47" y="241"/>
                </a:lnTo>
                <a:lnTo>
                  <a:pt x="100" y="195"/>
                </a:lnTo>
                <a:lnTo>
                  <a:pt x="154" y="160"/>
                </a:lnTo>
                <a:lnTo>
                  <a:pt x="222" y="135"/>
                </a:lnTo>
                <a:lnTo>
                  <a:pt x="286" y="111"/>
                </a:lnTo>
                <a:lnTo>
                  <a:pt x="347" y="98"/>
                </a:lnTo>
                <a:lnTo>
                  <a:pt x="410" y="86"/>
                </a:lnTo>
                <a:lnTo>
                  <a:pt x="473" y="73"/>
                </a:lnTo>
                <a:lnTo>
                  <a:pt x="536" y="60"/>
                </a:lnTo>
                <a:lnTo>
                  <a:pt x="599" y="48"/>
                </a:lnTo>
                <a:lnTo>
                  <a:pt x="663" y="35"/>
                </a:lnTo>
              </a:path>
            </a:pathLst>
          </a:custGeom>
          <a:noFill/>
          <a:ln w="21370" cap="sq">
            <a:solidFill>
              <a:srgbClr val="000000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6" name="path 36"/>
          <p:cNvSpPr/>
          <p:nvPr/>
        </p:nvSpPr>
        <p:spPr>
          <a:xfrm>
            <a:off x="758667" y="7447762"/>
            <a:ext cx="121101" cy="1075669"/>
          </a:xfrm>
          <a:custGeom>
            <a:avLst/>
            <a:gdLst/>
            <a:ahLst/>
            <a:cxnLst/>
            <a:rect l="0" t="0" r="0" b="0"/>
            <a:pathLst>
              <a:path w="190" h="1693">
                <a:moveTo>
                  <a:pt x="185" y="1688"/>
                </a:moveTo>
                <a:lnTo>
                  <a:pt x="95" y="1688"/>
                </a:lnTo>
                <a:moveTo>
                  <a:pt x="185" y="1609"/>
                </a:moveTo>
                <a:lnTo>
                  <a:pt x="95" y="1609"/>
                </a:lnTo>
                <a:moveTo>
                  <a:pt x="185" y="1542"/>
                </a:moveTo>
                <a:lnTo>
                  <a:pt x="5" y="1542"/>
                </a:lnTo>
                <a:moveTo>
                  <a:pt x="185" y="1463"/>
                </a:moveTo>
                <a:lnTo>
                  <a:pt x="95" y="1463"/>
                </a:lnTo>
                <a:moveTo>
                  <a:pt x="185" y="1396"/>
                </a:moveTo>
                <a:lnTo>
                  <a:pt x="95" y="1396"/>
                </a:lnTo>
                <a:moveTo>
                  <a:pt x="185" y="1318"/>
                </a:moveTo>
                <a:lnTo>
                  <a:pt x="95" y="1318"/>
                </a:lnTo>
                <a:moveTo>
                  <a:pt x="185" y="1250"/>
                </a:moveTo>
                <a:lnTo>
                  <a:pt x="5" y="1250"/>
                </a:lnTo>
                <a:moveTo>
                  <a:pt x="185" y="1172"/>
                </a:moveTo>
                <a:lnTo>
                  <a:pt x="95" y="1172"/>
                </a:lnTo>
                <a:moveTo>
                  <a:pt x="185" y="1105"/>
                </a:moveTo>
                <a:lnTo>
                  <a:pt x="95" y="1105"/>
                </a:lnTo>
                <a:moveTo>
                  <a:pt x="185" y="1026"/>
                </a:moveTo>
                <a:lnTo>
                  <a:pt x="95" y="1026"/>
                </a:lnTo>
                <a:moveTo>
                  <a:pt x="185" y="959"/>
                </a:moveTo>
                <a:lnTo>
                  <a:pt x="5" y="959"/>
                </a:lnTo>
                <a:moveTo>
                  <a:pt x="185" y="880"/>
                </a:moveTo>
                <a:lnTo>
                  <a:pt x="95" y="880"/>
                </a:lnTo>
                <a:moveTo>
                  <a:pt x="185" y="813"/>
                </a:moveTo>
                <a:lnTo>
                  <a:pt x="95" y="813"/>
                </a:lnTo>
                <a:moveTo>
                  <a:pt x="185" y="734"/>
                </a:moveTo>
                <a:lnTo>
                  <a:pt x="95" y="734"/>
                </a:lnTo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8" name="textbox 38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0" name="textbox 40"/>
          <p:cNvSpPr/>
          <p:nvPr/>
        </p:nvSpPr>
        <p:spPr>
          <a:xfrm>
            <a:off x="3805569" y="454610"/>
            <a:ext cx="495300" cy="2863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ct val="122000"/>
              </a:lnSpc>
              <a:tabLst>
                <a:tab pos="198120" algn="l"/>
              </a:tabLst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42" name="picture 4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818269" y="598385"/>
            <a:ext cx="121101" cy="99731"/>
          </a:xfrm>
          <a:prstGeom prst="rect">
            <a:avLst/>
          </a:prstGeom>
        </p:spPr>
      </p:pic>
      <p:pic>
        <p:nvPicPr>
          <p:cNvPr id="44" name="picture 4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477284"/>
            <a:ext cx="121101" cy="99730"/>
          </a:xfrm>
          <a:prstGeom prst="rect">
            <a:avLst/>
          </a:prstGeom>
        </p:spPr>
      </p:pic>
      <p:sp>
        <p:nvSpPr>
          <p:cNvPr id="46" name="textbox 46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8" name="textbox 48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0" name="textbox 50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2" name="path 52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4" name="path 54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6" name="path 56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8" name="path 58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0" name="path 60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path 62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4" name="path 64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6" name="textbox 66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8" name="path 68"/>
          <p:cNvSpPr/>
          <p:nvPr/>
        </p:nvSpPr>
        <p:spPr>
          <a:xfrm>
            <a:off x="787161" y="2860140"/>
            <a:ext cx="135349" cy="427418"/>
          </a:xfrm>
          <a:custGeom>
            <a:avLst/>
            <a:gdLst/>
            <a:ahLst/>
            <a:cxnLst/>
            <a:rect l="0" t="0" r="0" b="0"/>
            <a:pathLst>
              <a:path w="213" h="673">
                <a:moveTo>
                  <a:pt x="207" y="667"/>
                </a:moveTo>
                <a:lnTo>
                  <a:pt x="106" y="667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 70"/>
          <p:cNvSpPr/>
          <p:nvPr/>
        </p:nvSpPr>
        <p:spPr>
          <a:xfrm>
            <a:off x="787161" y="2347238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 72"/>
          <p:cNvSpPr/>
          <p:nvPr/>
        </p:nvSpPr>
        <p:spPr>
          <a:xfrm>
            <a:off x="787161" y="1307187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path 74"/>
          <p:cNvSpPr/>
          <p:nvPr/>
        </p:nvSpPr>
        <p:spPr>
          <a:xfrm>
            <a:off x="787161" y="787162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6" name="path 76"/>
          <p:cNvSpPr/>
          <p:nvPr/>
        </p:nvSpPr>
        <p:spPr>
          <a:xfrm>
            <a:off x="787161" y="1827213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8" name="textbox 78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80" name="picture 8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82" name="textbox 82"/>
          <p:cNvSpPr/>
          <p:nvPr/>
        </p:nvSpPr>
        <p:spPr>
          <a:xfrm rot="16200000">
            <a:off x="5064821" y="7915550"/>
            <a:ext cx="259715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4" name="textbox 84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6" name="textbox 86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8" name="path 88"/>
          <p:cNvSpPr/>
          <p:nvPr/>
        </p:nvSpPr>
        <p:spPr>
          <a:xfrm>
            <a:off x="787161" y="3380165"/>
            <a:ext cx="135349" cy="213709"/>
          </a:xfrm>
          <a:custGeom>
            <a:avLst/>
            <a:gdLst/>
            <a:ahLst/>
            <a:cxnLst/>
            <a:rect l="0" t="0" r="0" b="0"/>
            <a:pathLst>
              <a:path w="213" h="336"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 90"/>
          <p:cNvSpPr/>
          <p:nvPr/>
        </p:nvSpPr>
        <p:spPr>
          <a:xfrm>
            <a:off x="915387" y="787162"/>
            <a:ext cx="7123" cy="3120152"/>
          </a:xfrm>
          <a:custGeom>
            <a:avLst/>
            <a:gdLst/>
            <a:ahLst/>
            <a:cxnLst/>
            <a:rect l="0" t="0" r="0" b="0"/>
            <a:pathLst>
              <a:path w="11" h="4913">
                <a:moveTo>
                  <a:pt x="5" y="4908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rect 92"/>
          <p:cNvSpPr/>
          <p:nvPr/>
        </p:nvSpPr>
        <p:spPr>
          <a:xfrm>
            <a:off x="3381900" y="7613574"/>
            <a:ext cx="142473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rect 94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rect 96"/>
          <p:cNvSpPr/>
          <p:nvPr/>
        </p:nvSpPr>
        <p:spPr>
          <a:xfrm>
            <a:off x="1098199" y="7602667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textbox 98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0" name="textbox 100"/>
          <p:cNvSpPr/>
          <p:nvPr/>
        </p:nvSpPr>
        <p:spPr>
          <a:xfrm>
            <a:off x="1094927" y="7608361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2" name="textbox 102"/>
          <p:cNvSpPr/>
          <p:nvPr/>
        </p:nvSpPr>
        <p:spPr>
          <a:xfrm>
            <a:off x="3378609" y="7619269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4" name="path 104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path 106"/>
          <p:cNvSpPr/>
          <p:nvPr/>
        </p:nvSpPr>
        <p:spPr>
          <a:xfrm>
            <a:off x="815656" y="8559049"/>
            <a:ext cx="64112" cy="7123"/>
          </a:xfrm>
          <a:custGeom>
            <a:avLst/>
            <a:gdLst/>
            <a:ahLst/>
            <a:cxnLst/>
            <a:rect l="0" t="0" r="0" b="0"/>
            <a:pathLst>
              <a:path w="100" h="11"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path 108"/>
          <p:cNvSpPr/>
          <p:nvPr/>
        </p:nvSpPr>
        <p:spPr>
          <a:xfrm>
            <a:off x="872645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ath 2"/>
          <p:cNvSpPr/>
          <p:nvPr/>
        </p:nvSpPr>
        <p:spPr>
          <a:xfrm>
            <a:off x="2044196" y="831765"/>
            <a:ext cx="334312" cy="2971518"/>
          </a:xfrm>
          <a:custGeom>
            <a:avLst/>
            <a:gdLst/>
            <a:ahLst/>
            <a:cxnLst/>
            <a:rect l="0" t="0" r="0" b="0"/>
            <a:pathLst>
              <a:path w="526" h="4679">
                <a:moveTo>
                  <a:pt x="7" y="4655"/>
                </a:moveTo>
                <a:lnTo>
                  <a:pt x="35" y="4509"/>
                </a:lnTo>
                <a:lnTo>
                  <a:pt x="64" y="4326"/>
                </a:lnTo>
                <a:lnTo>
                  <a:pt x="92" y="4063"/>
                </a:lnTo>
                <a:lnTo>
                  <a:pt x="121" y="3782"/>
                </a:lnTo>
                <a:lnTo>
                  <a:pt x="149" y="3553"/>
                </a:lnTo>
                <a:lnTo>
                  <a:pt x="177" y="3213"/>
                </a:lnTo>
                <a:lnTo>
                  <a:pt x="206" y="2984"/>
                </a:lnTo>
                <a:lnTo>
                  <a:pt x="234" y="2474"/>
                </a:lnTo>
                <a:lnTo>
                  <a:pt x="263" y="1507"/>
                </a:lnTo>
                <a:lnTo>
                  <a:pt x="291" y="515"/>
                </a:lnTo>
                <a:lnTo>
                  <a:pt x="320" y="7"/>
                </a:lnTo>
                <a:lnTo>
                  <a:pt x="348" y="684"/>
                </a:lnTo>
                <a:lnTo>
                  <a:pt x="376" y="1760"/>
                </a:lnTo>
                <a:lnTo>
                  <a:pt x="405" y="2935"/>
                </a:lnTo>
                <a:lnTo>
                  <a:pt x="433" y="3684"/>
                </a:lnTo>
                <a:lnTo>
                  <a:pt x="462" y="4229"/>
                </a:lnTo>
                <a:lnTo>
                  <a:pt x="490" y="4547"/>
                </a:lnTo>
                <a:lnTo>
                  <a:pt x="519" y="4672"/>
                </a:lnTo>
              </a:path>
            </a:pathLst>
          </a:custGeom>
          <a:noFill/>
          <a:ln w="9260" cap="rnd">
            <a:solidFill>
              <a:srgbClr val="000000"/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" name="path 4"/>
          <p:cNvSpPr/>
          <p:nvPr/>
        </p:nvSpPr>
        <p:spPr>
          <a:xfrm>
            <a:off x="2026138" y="3783152"/>
            <a:ext cx="1562284" cy="89237"/>
          </a:xfrm>
          <a:custGeom>
            <a:avLst/>
            <a:gdLst/>
            <a:ahLst/>
            <a:cxnLst/>
            <a:rect l="0" t="0" r="0" b="0"/>
            <a:pathLst>
              <a:path w="2460" h="140">
                <a:moveTo>
                  <a:pt x="7" y="108"/>
                </a:moveTo>
                <a:lnTo>
                  <a:pt x="35" y="7"/>
                </a:lnTo>
                <a:moveTo>
                  <a:pt x="547" y="24"/>
                </a:moveTo>
                <a:lnTo>
                  <a:pt x="576" y="58"/>
                </a:lnTo>
                <a:lnTo>
                  <a:pt x="604" y="99"/>
                </a:lnTo>
                <a:lnTo>
                  <a:pt x="632" y="133"/>
                </a:lnTo>
                <a:moveTo>
                  <a:pt x="1997" y="119"/>
                </a:moveTo>
                <a:lnTo>
                  <a:pt x="2026" y="102"/>
                </a:lnTo>
                <a:lnTo>
                  <a:pt x="2054" y="113"/>
                </a:lnTo>
                <a:lnTo>
                  <a:pt x="2083" y="92"/>
                </a:lnTo>
                <a:lnTo>
                  <a:pt x="2111" y="129"/>
                </a:lnTo>
                <a:lnTo>
                  <a:pt x="2140" y="103"/>
                </a:lnTo>
                <a:lnTo>
                  <a:pt x="2168" y="89"/>
                </a:lnTo>
                <a:lnTo>
                  <a:pt x="2197" y="83"/>
                </a:lnTo>
                <a:lnTo>
                  <a:pt x="2225" y="69"/>
                </a:lnTo>
                <a:lnTo>
                  <a:pt x="2253" y="30"/>
                </a:lnTo>
                <a:lnTo>
                  <a:pt x="2282" y="21"/>
                </a:lnTo>
                <a:lnTo>
                  <a:pt x="2310" y="15"/>
                </a:lnTo>
                <a:lnTo>
                  <a:pt x="2339" y="28"/>
                </a:lnTo>
                <a:lnTo>
                  <a:pt x="2367" y="14"/>
                </a:lnTo>
                <a:lnTo>
                  <a:pt x="2396" y="56"/>
                </a:lnTo>
                <a:lnTo>
                  <a:pt x="2424" y="105"/>
                </a:lnTo>
                <a:lnTo>
                  <a:pt x="2452" y="121"/>
                </a:lnTo>
              </a:path>
            </a:pathLst>
          </a:custGeom>
          <a:noFill/>
          <a:ln w="9260" cap="rnd">
            <a:solidFill>
              <a:srgbClr val="000000"/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6" name="picture 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915387" y="3899554"/>
            <a:ext cx="3625931" cy="135985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 rot="21600000">
            <a:off x="787161" y="3847600"/>
            <a:ext cx="3758357" cy="59714"/>
            <a:chOff x="0" y="0"/>
            <a:chExt cx="3758357" cy="59714"/>
          </a:xfrm>
        </p:grpSpPr>
        <p:sp>
          <p:nvSpPr>
            <p:cNvPr id="8" name="path 8"/>
            <p:cNvSpPr/>
            <p:nvPr/>
          </p:nvSpPr>
          <p:spPr>
            <a:xfrm>
              <a:off x="137412" y="0"/>
              <a:ext cx="3620944" cy="58179"/>
            </a:xfrm>
            <a:custGeom>
              <a:avLst/>
              <a:gdLst/>
              <a:ahLst/>
              <a:cxnLst/>
              <a:rect l="0" t="0" r="0" b="0"/>
              <a:pathLst>
                <a:path w="5702" h="91">
                  <a:moveTo>
                    <a:pt x="7" y="84"/>
                  </a:moveTo>
                  <a:lnTo>
                    <a:pt x="35" y="84"/>
                  </a:lnTo>
                  <a:lnTo>
                    <a:pt x="64" y="84"/>
                  </a:lnTo>
                  <a:lnTo>
                    <a:pt x="92" y="84"/>
                  </a:lnTo>
                  <a:lnTo>
                    <a:pt x="121" y="84"/>
                  </a:lnTo>
                  <a:lnTo>
                    <a:pt x="149" y="84"/>
                  </a:lnTo>
                  <a:lnTo>
                    <a:pt x="177" y="84"/>
                  </a:lnTo>
                  <a:lnTo>
                    <a:pt x="206" y="84"/>
                  </a:lnTo>
                  <a:lnTo>
                    <a:pt x="234" y="84"/>
                  </a:lnTo>
                  <a:lnTo>
                    <a:pt x="263" y="84"/>
                  </a:lnTo>
                  <a:lnTo>
                    <a:pt x="291" y="84"/>
                  </a:lnTo>
                  <a:lnTo>
                    <a:pt x="320" y="84"/>
                  </a:lnTo>
                  <a:lnTo>
                    <a:pt x="348" y="84"/>
                  </a:lnTo>
                  <a:lnTo>
                    <a:pt x="376" y="84"/>
                  </a:lnTo>
                  <a:lnTo>
                    <a:pt x="405" y="84"/>
                  </a:lnTo>
                  <a:lnTo>
                    <a:pt x="433" y="84"/>
                  </a:lnTo>
                  <a:lnTo>
                    <a:pt x="462" y="84"/>
                  </a:lnTo>
                  <a:lnTo>
                    <a:pt x="490" y="84"/>
                  </a:lnTo>
                  <a:lnTo>
                    <a:pt x="519" y="84"/>
                  </a:lnTo>
                  <a:lnTo>
                    <a:pt x="547" y="84"/>
                  </a:lnTo>
                  <a:lnTo>
                    <a:pt x="576" y="84"/>
                  </a:lnTo>
                  <a:lnTo>
                    <a:pt x="604" y="84"/>
                  </a:lnTo>
                  <a:lnTo>
                    <a:pt x="632" y="84"/>
                  </a:lnTo>
                  <a:lnTo>
                    <a:pt x="661" y="84"/>
                  </a:lnTo>
                  <a:lnTo>
                    <a:pt x="689" y="84"/>
                  </a:lnTo>
                  <a:lnTo>
                    <a:pt x="718" y="84"/>
                  </a:lnTo>
                  <a:lnTo>
                    <a:pt x="746" y="84"/>
                  </a:lnTo>
                  <a:lnTo>
                    <a:pt x="775" y="84"/>
                  </a:lnTo>
                  <a:lnTo>
                    <a:pt x="803" y="84"/>
                  </a:lnTo>
                  <a:lnTo>
                    <a:pt x="832" y="84"/>
                  </a:lnTo>
                  <a:lnTo>
                    <a:pt x="860" y="84"/>
                  </a:lnTo>
                  <a:lnTo>
                    <a:pt x="888" y="84"/>
                  </a:lnTo>
                  <a:lnTo>
                    <a:pt x="917" y="84"/>
                  </a:lnTo>
                  <a:lnTo>
                    <a:pt x="945" y="84"/>
                  </a:lnTo>
                  <a:lnTo>
                    <a:pt x="974" y="84"/>
                  </a:lnTo>
                  <a:lnTo>
                    <a:pt x="1002" y="84"/>
                  </a:lnTo>
                  <a:lnTo>
                    <a:pt x="1031" y="84"/>
                  </a:lnTo>
                  <a:lnTo>
                    <a:pt x="1059" y="84"/>
                  </a:lnTo>
                  <a:lnTo>
                    <a:pt x="1087" y="84"/>
                  </a:lnTo>
                  <a:lnTo>
                    <a:pt x="1116" y="84"/>
                  </a:lnTo>
                  <a:lnTo>
                    <a:pt x="1144" y="84"/>
                  </a:lnTo>
                  <a:lnTo>
                    <a:pt x="1173" y="84"/>
                  </a:lnTo>
                  <a:lnTo>
                    <a:pt x="1201" y="84"/>
                  </a:lnTo>
                  <a:lnTo>
                    <a:pt x="1230" y="84"/>
                  </a:lnTo>
                  <a:lnTo>
                    <a:pt x="1258" y="84"/>
                  </a:lnTo>
                  <a:lnTo>
                    <a:pt x="1287" y="84"/>
                  </a:lnTo>
                  <a:lnTo>
                    <a:pt x="1315" y="84"/>
                  </a:lnTo>
                  <a:lnTo>
                    <a:pt x="1343" y="84"/>
                  </a:lnTo>
                  <a:lnTo>
                    <a:pt x="1372" y="81"/>
                  </a:lnTo>
                  <a:lnTo>
                    <a:pt x="1400" y="79"/>
                  </a:lnTo>
                  <a:lnTo>
                    <a:pt x="1429" y="80"/>
                  </a:lnTo>
                  <a:lnTo>
                    <a:pt x="1457" y="62"/>
                  </a:lnTo>
                  <a:lnTo>
                    <a:pt x="1486" y="74"/>
                  </a:lnTo>
                  <a:lnTo>
                    <a:pt x="1514" y="73"/>
                  </a:lnTo>
                  <a:lnTo>
                    <a:pt x="1542" y="72"/>
                  </a:lnTo>
                  <a:lnTo>
                    <a:pt x="1571" y="72"/>
                  </a:lnTo>
                  <a:lnTo>
                    <a:pt x="1599" y="69"/>
                  </a:lnTo>
                  <a:lnTo>
                    <a:pt x="1628" y="69"/>
                  </a:lnTo>
                  <a:lnTo>
                    <a:pt x="1656" y="65"/>
                  </a:lnTo>
                  <a:lnTo>
                    <a:pt x="1685" y="62"/>
                  </a:lnTo>
                  <a:lnTo>
                    <a:pt x="1713" y="52"/>
                  </a:lnTo>
                  <a:lnTo>
                    <a:pt x="1742" y="7"/>
                  </a:lnTo>
                  <a:moveTo>
                    <a:pt x="2367" y="31"/>
                  </a:moveTo>
                  <a:lnTo>
                    <a:pt x="2396" y="25"/>
                  </a:lnTo>
                  <a:lnTo>
                    <a:pt x="2424" y="48"/>
                  </a:lnTo>
                  <a:lnTo>
                    <a:pt x="2452" y="46"/>
                  </a:lnTo>
                  <a:lnTo>
                    <a:pt x="2481" y="48"/>
                  </a:lnTo>
                  <a:lnTo>
                    <a:pt x="2509" y="34"/>
                  </a:lnTo>
                  <a:lnTo>
                    <a:pt x="2538" y="58"/>
                  </a:lnTo>
                  <a:lnTo>
                    <a:pt x="2566" y="48"/>
                  </a:lnTo>
                  <a:lnTo>
                    <a:pt x="2595" y="62"/>
                  </a:lnTo>
                  <a:lnTo>
                    <a:pt x="2623" y="54"/>
                  </a:lnTo>
                  <a:lnTo>
                    <a:pt x="2652" y="51"/>
                  </a:lnTo>
                  <a:lnTo>
                    <a:pt x="2680" y="57"/>
                  </a:lnTo>
                  <a:lnTo>
                    <a:pt x="2708" y="51"/>
                  </a:lnTo>
                  <a:lnTo>
                    <a:pt x="2737" y="57"/>
                  </a:lnTo>
                  <a:lnTo>
                    <a:pt x="2765" y="65"/>
                  </a:lnTo>
                  <a:lnTo>
                    <a:pt x="2794" y="59"/>
                  </a:lnTo>
                  <a:lnTo>
                    <a:pt x="2822" y="57"/>
                  </a:lnTo>
                  <a:lnTo>
                    <a:pt x="2851" y="58"/>
                  </a:lnTo>
                  <a:lnTo>
                    <a:pt x="2879" y="63"/>
                  </a:lnTo>
                  <a:lnTo>
                    <a:pt x="2908" y="59"/>
                  </a:lnTo>
                  <a:lnTo>
                    <a:pt x="2936" y="63"/>
                  </a:lnTo>
                  <a:lnTo>
                    <a:pt x="2964" y="57"/>
                  </a:lnTo>
                  <a:lnTo>
                    <a:pt x="2993" y="63"/>
                  </a:lnTo>
                  <a:lnTo>
                    <a:pt x="3021" y="65"/>
                  </a:lnTo>
                  <a:lnTo>
                    <a:pt x="3050" y="65"/>
                  </a:lnTo>
                  <a:lnTo>
                    <a:pt x="3078" y="56"/>
                  </a:lnTo>
                  <a:lnTo>
                    <a:pt x="3107" y="62"/>
                  </a:lnTo>
                  <a:lnTo>
                    <a:pt x="3135" y="52"/>
                  </a:lnTo>
                  <a:lnTo>
                    <a:pt x="3163" y="65"/>
                  </a:lnTo>
                  <a:lnTo>
                    <a:pt x="3192" y="62"/>
                  </a:lnTo>
                  <a:lnTo>
                    <a:pt x="3220" y="56"/>
                  </a:lnTo>
                  <a:lnTo>
                    <a:pt x="3249" y="67"/>
                  </a:lnTo>
                  <a:lnTo>
                    <a:pt x="3277" y="67"/>
                  </a:lnTo>
                  <a:lnTo>
                    <a:pt x="3306" y="56"/>
                  </a:lnTo>
                  <a:lnTo>
                    <a:pt x="3334" y="53"/>
                  </a:lnTo>
                  <a:lnTo>
                    <a:pt x="3363" y="58"/>
                  </a:lnTo>
                  <a:lnTo>
                    <a:pt x="3391" y="58"/>
                  </a:lnTo>
                  <a:lnTo>
                    <a:pt x="3419" y="56"/>
                  </a:lnTo>
                  <a:lnTo>
                    <a:pt x="3448" y="59"/>
                  </a:lnTo>
                  <a:lnTo>
                    <a:pt x="3476" y="63"/>
                  </a:lnTo>
                  <a:lnTo>
                    <a:pt x="3505" y="62"/>
                  </a:lnTo>
                  <a:lnTo>
                    <a:pt x="3533" y="56"/>
                  </a:lnTo>
                  <a:lnTo>
                    <a:pt x="3562" y="57"/>
                  </a:lnTo>
                  <a:lnTo>
                    <a:pt x="3590" y="41"/>
                  </a:lnTo>
                  <a:lnTo>
                    <a:pt x="3618" y="40"/>
                  </a:lnTo>
                  <a:lnTo>
                    <a:pt x="3647" y="32"/>
                  </a:lnTo>
                  <a:lnTo>
                    <a:pt x="3675" y="31"/>
                  </a:lnTo>
                  <a:lnTo>
                    <a:pt x="3704" y="25"/>
                  </a:lnTo>
                  <a:lnTo>
                    <a:pt x="3732" y="18"/>
                  </a:lnTo>
                  <a:moveTo>
                    <a:pt x="4187" y="19"/>
                  </a:moveTo>
                  <a:lnTo>
                    <a:pt x="4216" y="26"/>
                  </a:lnTo>
                  <a:lnTo>
                    <a:pt x="4244" y="50"/>
                  </a:lnTo>
                  <a:lnTo>
                    <a:pt x="4273" y="57"/>
                  </a:lnTo>
                  <a:lnTo>
                    <a:pt x="4301" y="73"/>
                  </a:lnTo>
                  <a:lnTo>
                    <a:pt x="4329" y="68"/>
                  </a:lnTo>
                  <a:lnTo>
                    <a:pt x="4358" y="76"/>
                  </a:lnTo>
                  <a:lnTo>
                    <a:pt x="4386" y="76"/>
                  </a:lnTo>
                  <a:lnTo>
                    <a:pt x="4415" y="81"/>
                  </a:lnTo>
                  <a:lnTo>
                    <a:pt x="4443" y="78"/>
                  </a:lnTo>
                  <a:lnTo>
                    <a:pt x="4472" y="78"/>
                  </a:lnTo>
                  <a:lnTo>
                    <a:pt x="4500" y="78"/>
                  </a:lnTo>
                  <a:lnTo>
                    <a:pt x="4529" y="80"/>
                  </a:lnTo>
                  <a:lnTo>
                    <a:pt x="4557" y="81"/>
                  </a:lnTo>
                  <a:lnTo>
                    <a:pt x="4585" y="83"/>
                  </a:lnTo>
                  <a:lnTo>
                    <a:pt x="4614" y="84"/>
                  </a:lnTo>
                  <a:lnTo>
                    <a:pt x="4642" y="83"/>
                  </a:lnTo>
                  <a:lnTo>
                    <a:pt x="4671" y="81"/>
                  </a:lnTo>
                  <a:lnTo>
                    <a:pt x="4699" y="84"/>
                  </a:lnTo>
                  <a:lnTo>
                    <a:pt x="4728" y="83"/>
                  </a:lnTo>
                  <a:lnTo>
                    <a:pt x="4756" y="83"/>
                  </a:lnTo>
                  <a:lnTo>
                    <a:pt x="4784" y="83"/>
                  </a:lnTo>
                  <a:lnTo>
                    <a:pt x="4813" y="84"/>
                  </a:lnTo>
                  <a:lnTo>
                    <a:pt x="4841" y="81"/>
                  </a:lnTo>
                  <a:lnTo>
                    <a:pt x="4870" y="83"/>
                  </a:lnTo>
                  <a:lnTo>
                    <a:pt x="4898" y="83"/>
                  </a:lnTo>
                  <a:lnTo>
                    <a:pt x="4927" y="83"/>
                  </a:lnTo>
                  <a:lnTo>
                    <a:pt x="4955" y="84"/>
                  </a:lnTo>
                  <a:lnTo>
                    <a:pt x="4984" y="84"/>
                  </a:lnTo>
                  <a:lnTo>
                    <a:pt x="5012" y="81"/>
                  </a:lnTo>
                  <a:lnTo>
                    <a:pt x="5040" y="83"/>
                  </a:lnTo>
                  <a:lnTo>
                    <a:pt x="5069" y="81"/>
                  </a:lnTo>
                  <a:lnTo>
                    <a:pt x="5097" y="83"/>
                  </a:lnTo>
                  <a:lnTo>
                    <a:pt x="5126" y="84"/>
                  </a:lnTo>
                  <a:lnTo>
                    <a:pt x="5154" y="84"/>
                  </a:lnTo>
                  <a:lnTo>
                    <a:pt x="5183" y="84"/>
                  </a:lnTo>
                  <a:lnTo>
                    <a:pt x="5211" y="84"/>
                  </a:lnTo>
                  <a:lnTo>
                    <a:pt x="5239" y="84"/>
                  </a:lnTo>
                  <a:lnTo>
                    <a:pt x="5268" y="83"/>
                  </a:lnTo>
                  <a:lnTo>
                    <a:pt x="5296" y="84"/>
                  </a:lnTo>
                  <a:lnTo>
                    <a:pt x="5325" y="84"/>
                  </a:lnTo>
                  <a:lnTo>
                    <a:pt x="5353" y="84"/>
                  </a:lnTo>
                  <a:lnTo>
                    <a:pt x="5382" y="83"/>
                  </a:lnTo>
                  <a:lnTo>
                    <a:pt x="5410" y="84"/>
                  </a:lnTo>
                  <a:lnTo>
                    <a:pt x="5439" y="84"/>
                  </a:lnTo>
                  <a:lnTo>
                    <a:pt x="5467" y="84"/>
                  </a:lnTo>
                  <a:lnTo>
                    <a:pt x="5495" y="84"/>
                  </a:lnTo>
                  <a:lnTo>
                    <a:pt x="5524" y="84"/>
                  </a:lnTo>
                  <a:lnTo>
                    <a:pt x="5552" y="84"/>
                  </a:lnTo>
                  <a:lnTo>
                    <a:pt x="5581" y="84"/>
                  </a:lnTo>
                  <a:lnTo>
                    <a:pt x="5609" y="84"/>
                  </a:lnTo>
                  <a:lnTo>
                    <a:pt x="5638" y="84"/>
                  </a:lnTo>
                  <a:lnTo>
                    <a:pt x="5666" y="84"/>
                  </a:lnTo>
                  <a:lnTo>
                    <a:pt x="5694" y="84"/>
                  </a:lnTo>
                </a:path>
              </a:pathLst>
            </a:custGeom>
            <a:noFill/>
            <a:ln w="9260" cap="rnd">
              <a:solidFill>
                <a:srgbClr val="000000"/>
              </a:solidFill>
              <a:prstDash val="solid"/>
              <a:round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0" name="path 10"/>
            <p:cNvSpPr/>
            <p:nvPr/>
          </p:nvSpPr>
          <p:spPr>
            <a:xfrm>
              <a:off x="0" y="52591"/>
              <a:ext cx="3754156" cy="7123"/>
            </a:xfrm>
            <a:custGeom>
              <a:avLst/>
              <a:gdLst/>
              <a:ahLst/>
              <a:cxnLst/>
              <a:rect l="0" t="0" r="0" b="0"/>
              <a:pathLst>
                <a:path w="5912" h="11">
                  <a:moveTo>
                    <a:pt x="207" y="5"/>
                  </a:moveTo>
                  <a:lnTo>
                    <a:pt x="5906" y="5"/>
                  </a:lnTo>
                  <a:moveTo>
                    <a:pt x="207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12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929204" y="1388647"/>
            <a:ext cx="3611684" cy="2512500"/>
          </a:xfrm>
          <a:prstGeom prst="rect">
            <a:avLst/>
          </a:prstGeom>
        </p:spPr>
      </p:pic>
      <p:sp>
        <p:nvSpPr>
          <p:cNvPr id="14" name="textbox 14"/>
          <p:cNvSpPr/>
          <p:nvPr/>
        </p:nvSpPr>
        <p:spPr>
          <a:xfrm>
            <a:off x="5148708" y="463314"/>
            <a:ext cx="2123439" cy="33096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7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200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31222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3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.fcs       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-Dec-20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0.29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2.08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26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1.99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.45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1:</a:t>
            </a:r>
            <a:r>
              <a:rPr sz="900" kern="0" spc="1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7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5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.45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9025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9025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1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 409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1.462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16" name="pictur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 rot="21600000">
            <a:off x="3095220" y="7426391"/>
            <a:ext cx="1353491" cy="1303625"/>
            <a:chOff x="0" y="0"/>
            <a:chExt cx="1353491" cy="1303625"/>
          </a:xfrm>
        </p:grpSpPr>
        <p:sp>
          <p:nvSpPr>
            <p:cNvPr id="18" name="path 18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0" name="path 20"/>
            <p:cNvSpPr/>
            <p:nvPr/>
          </p:nvSpPr>
          <p:spPr>
            <a:xfrm>
              <a:off x="376856" y="634992"/>
              <a:ext cx="720723" cy="554654"/>
            </a:xfrm>
            <a:custGeom>
              <a:avLst/>
              <a:gdLst/>
              <a:ahLst/>
              <a:cxnLst/>
              <a:rect l="0" t="0" r="0" b="0"/>
              <a:pathLst>
                <a:path w="1134" h="873">
                  <a:moveTo>
                    <a:pt x="1082" y="76"/>
                  </a:moveTo>
                  <a:lnTo>
                    <a:pt x="1104" y="153"/>
                  </a:lnTo>
                  <a:lnTo>
                    <a:pt x="1118" y="222"/>
                  </a:lnTo>
                  <a:lnTo>
                    <a:pt x="1118" y="267"/>
                  </a:lnTo>
                  <a:lnTo>
                    <a:pt x="1118" y="312"/>
                  </a:lnTo>
                  <a:lnTo>
                    <a:pt x="1113" y="389"/>
                  </a:lnTo>
                  <a:lnTo>
                    <a:pt x="1087" y="483"/>
                  </a:lnTo>
                  <a:lnTo>
                    <a:pt x="1052" y="560"/>
                  </a:lnTo>
                  <a:lnTo>
                    <a:pt x="1012" y="625"/>
                  </a:lnTo>
                  <a:lnTo>
                    <a:pt x="959" y="676"/>
                  </a:lnTo>
                  <a:lnTo>
                    <a:pt x="906" y="723"/>
                  </a:lnTo>
                  <a:lnTo>
                    <a:pt x="840" y="766"/>
                  </a:lnTo>
                  <a:lnTo>
                    <a:pt x="778" y="800"/>
                  </a:lnTo>
                  <a:lnTo>
                    <a:pt x="699" y="830"/>
                  </a:lnTo>
                  <a:lnTo>
                    <a:pt x="615" y="843"/>
                  </a:lnTo>
                  <a:lnTo>
                    <a:pt x="545" y="852"/>
                  </a:lnTo>
                  <a:lnTo>
                    <a:pt x="474" y="852"/>
                  </a:lnTo>
                  <a:lnTo>
                    <a:pt x="400" y="856"/>
                  </a:lnTo>
                  <a:lnTo>
                    <a:pt x="325" y="856"/>
                  </a:lnTo>
                  <a:lnTo>
                    <a:pt x="254" y="856"/>
                  </a:lnTo>
                  <a:lnTo>
                    <a:pt x="175" y="830"/>
                  </a:lnTo>
                  <a:lnTo>
                    <a:pt x="104" y="800"/>
                  </a:lnTo>
                  <a:lnTo>
                    <a:pt x="47" y="749"/>
                  </a:lnTo>
                  <a:lnTo>
                    <a:pt x="21" y="668"/>
                  </a:lnTo>
                  <a:lnTo>
                    <a:pt x="16" y="595"/>
                  </a:lnTo>
                  <a:lnTo>
                    <a:pt x="16" y="558"/>
                  </a:lnTo>
                  <a:lnTo>
                    <a:pt x="16" y="522"/>
                  </a:lnTo>
                  <a:lnTo>
                    <a:pt x="38" y="453"/>
                  </a:lnTo>
                  <a:lnTo>
                    <a:pt x="82" y="381"/>
                  </a:lnTo>
                  <a:lnTo>
                    <a:pt x="126" y="312"/>
                  </a:lnTo>
                  <a:lnTo>
                    <a:pt x="171" y="256"/>
                  </a:lnTo>
                  <a:lnTo>
                    <a:pt x="223" y="205"/>
                  </a:lnTo>
                  <a:lnTo>
                    <a:pt x="294" y="145"/>
                  </a:lnTo>
                  <a:lnTo>
                    <a:pt x="360" y="102"/>
                  </a:lnTo>
                  <a:lnTo>
                    <a:pt x="426" y="68"/>
                  </a:lnTo>
                  <a:lnTo>
                    <a:pt x="492" y="38"/>
                  </a:lnTo>
                  <a:lnTo>
                    <a:pt x="580" y="21"/>
                  </a:lnTo>
                  <a:lnTo>
                    <a:pt x="660" y="16"/>
                  </a:lnTo>
                  <a:lnTo>
                    <a:pt x="730" y="16"/>
                  </a:lnTo>
                  <a:lnTo>
                    <a:pt x="805" y="21"/>
                  </a:lnTo>
                  <a:lnTo>
                    <a:pt x="831" y="25"/>
                  </a:lnTo>
                  <a:lnTo>
                    <a:pt x="894" y="38"/>
                  </a:lnTo>
                  <a:lnTo>
                    <a:pt x="957" y="51"/>
                  </a:lnTo>
                  <a:lnTo>
                    <a:pt x="1020" y="63"/>
                  </a:lnTo>
                  <a:lnTo>
                    <a:pt x="1082" y="76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22" name="picture 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 rot="21600000">
            <a:off x="5431773" y="7426391"/>
            <a:ext cx="1353491" cy="1303625"/>
            <a:chOff x="0" y="0"/>
            <a:chExt cx="1353491" cy="1303625"/>
          </a:xfrm>
        </p:grpSpPr>
        <p:sp>
          <p:nvSpPr>
            <p:cNvPr id="24" name="path 24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6" name="path 26"/>
            <p:cNvSpPr/>
            <p:nvPr/>
          </p:nvSpPr>
          <p:spPr>
            <a:xfrm>
              <a:off x="334972" y="537042"/>
              <a:ext cx="729115" cy="598187"/>
            </a:xfrm>
            <a:custGeom>
              <a:avLst/>
              <a:gdLst/>
              <a:ahLst/>
              <a:cxnLst/>
              <a:rect l="0" t="0" r="0" b="0"/>
              <a:pathLst>
                <a:path w="1148" h="942">
                  <a:moveTo>
                    <a:pt x="928" y="21"/>
                  </a:moveTo>
                  <a:lnTo>
                    <a:pt x="986" y="72"/>
                  </a:lnTo>
                  <a:lnTo>
                    <a:pt x="1047" y="132"/>
                  </a:lnTo>
                  <a:lnTo>
                    <a:pt x="1091" y="213"/>
                  </a:lnTo>
                  <a:lnTo>
                    <a:pt x="1122" y="299"/>
                  </a:lnTo>
                  <a:lnTo>
                    <a:pt x="1131" y="372"/>
                  </a:lnTo>
                  <a:lnTo>
                    <a:pt x="1131" y="411"/>
                  </a:lnTo>
                  <a:lnTo>
                    <a:pt x="1131" y="449"/>
                  </a:lnTo>
                  <a:lnTo>
                    <a:pt x="1096" y="531"/>
                  </a:lnTo>
                  <a:lnTo>
                    <a:pt x="1052" y="590"/>
                  </a:lnTo>
                  <a:lnTo>
                    <a:pt x="999" y="642"/>
                  </a:lnTo>
                  <a:lnTo>
                    <a:pt x="941" y="702"/>
                  </a:lnTo>
                  <a:lnTo>
                    <a:pt x="880" y="758"/>
                  </a:lnTo>
                  <a:lnTo>
                    <a:pt x="823" y="805"/>
                  </a:lnTo>
                  <a:lnTo>
                    <a:pt x="765" y="848"/>
                  </a:lnTo>
                  <a:lnTo>
                    <a:pt x="704" y="886"/>
                  </a:lnTo>
                  <a:lnTo>
                    <a:pt x="629" y="908"/>
                  </a:lnTo>
                  <a:lnTo>
                    <a:pt x="554" y="920"/>
                  </a:lnTo>
                  <a:lnTo>
                    <a:pt x="474" y="925"/>
                  </a:lnTo>
                  <a:lnTo>
                    <a:pt x="400" y="925"/>
                  </a:lnTo>
                  <a:lnTo>
                    <a:pt x="329" y="916"/>
                  </a:lnTo>
                  <a:lnTo>
                    <a:pt x="259" y="895"/>
                  </a:lnTo>
                  <a:lnTo>
                    <a:pt x="193" y="860"/>
                  </a:lnTo>
                  <a:lnTo>
                    <a:pt x="140" y="813"/>
                  </a:lnTo>
                  <a:lnTo>
                    <a:pt x="78" y="766"/>
                  </a:lnTo>
                  <a:lnTo>
                    <a:pt x="30" y="706"/>
                  </a:lnTo>
                  <a:lnTo>
                    <a:pt x="16" y="638"/>
                  </a:lnTo>
                  <a:lnTo>
                    <a:pt x="21" y="569"/>
                  </a:lnTo>
                  <a:lnTo>
                    <a:pt x="43" y="501"/>
                  </a:lnTo>
                  <a:lnTo>
                    <a:pt x="69" y="436"/>
                  </a:lnTo>
                  <a:lnTo>
                    <a:pt x="100" y="372"/>
                  </a:lnTo>
                  <a:lnTo>
                    <a:pt x="144" y="312"/>
                  </a:lnTo>
                  <a:lnTo>
                    <a:pt x="201" y="248"/>
                  </a:lnTo>
                  <a:lnTo>
                    <a:pt x="259" y="205"/>
                  </a:lnTo>
                  <a:lnTo>
                    <a:pt x="316" y="162"/>
                  </a:lnTo>
                  <a:lnTo>
                    <a:pt x="382" y="132"/>
                  </a:lnTo>
                  <a:lnTo>
                    <a:pt x="452" y="98"/>
                  </a:lnTo>
                  <a:lnTo>
                    <a:pt x="519" y="68"/>
                  </a:lnTo>
                  <a:lnTo>
                    <a:pt x="589" y="42"/>
                  </a:lnTo>
                  <a:lnTo>
                    <a:pt x="660" y="21"/>
                  </a:lnTo>
                  <a:lnTo>
                    <a:pt x="673" y="16"/>
                  </a:lnTo>
                  <a:lnTo>
                    <a:pt x="737" y="17"/>
                  </a:lnTo>
                  <a:lnTo>
                    <a:pt x="800" y="18"/>
                  </a:lnTo>
                  <a:lnTo>
                    <a:pt x="864" y="20"/>
                  </a:lnTo>
                  <a:lnTo>
                    <a:pt x="928" y="21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28" name="picture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sp>
        <p:nvSpPr>
          <p:cNvPr id="30" name="textbox 30"/>
          <p:cNvSpPr/>
          <p:nvPr/>
        </p:nvSpPr>
        <p:spPr>
          <a:xfrm>
            <a:off x="882499" y="4078020"/>
            <a:ext cx="3767454" cy="3124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741170" algn="l" rtl="0" eaLnBrk="0">
              <a:lnSpc>
                <a:spcPts val="1270"/>
              </a:lnSpc>
              <a:spcBef>
                <a:spcPts val="11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2" name="textbox 32"/>
          <p:cNvSpPr/>
          <p:nvPr/>
        </p:nvSpPr>
        <p:spPr>
          <a:xfrm>
            <a:off x="5519459" y="8760429"/>
            <a:ext cx="1303019" cy="32639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537210" indent="-525145" algn="l" rtl="0" eaLnBrk="0">
              <a:lnSpc>
                <a:spcPct val="116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 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80</a:t>
            </a:r>
            <a:r>
              <a:rPr sz="700" kern="0" spc="1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  120  </a:t>
            </a: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4" name="textbox 34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6" name="textbox 36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8" name="textbox 38"/>
          <p:cNvSpPr/>
          <p:nvPr/>
        </p:nvSpPr>
        <p:spPr>
          <a:xfrm rot="16200000">
            <a:off x="-952306" y="2214200"/>
            <a:ext cx="3289934" cy="16256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0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0" name="path 40"/>
          <p:cNvSpPr/>
          <p:nvPr/>
        </p:nvSpPr>
        <p:spPr>
          <a:xfrm>
            <a:off x="1166600" y="8053654"/>
            <a:ext cx="651294" cy="325403"/>
          </a:xfrm>
          <a:custGeom>
            <a:avLst/>
            <a:gdLst/>
            <a:ahLst/>
            <a:cxnLst/>
            <a:rect l="0" t="0" r="0" b="0"/>
            <a:pathLst>
              <a:path w="1025" h="512">
                <a:moveTo>
                  <a:pt x="663" y="35"/>
                </a:moveTo>
                <a:lnTo>
                  <a:pt x="732" y="25"/>
                </a:lnTo>
                <a:lnTo>
                  <a:pt x="822" y="16"/>
                </a:lnTo>
                <a:lnTo>
                  <a:pt x="902" y="20"/>
                </a:lnTo>
                <a:lnTo>
                  <a:pt x="964" y="42"/>
                </a:lnTo>
                <a:lnTo>
                  <a:pt x="995" y="96"/>
                </a:lnTo>
                <a:lnTo>
                  <a:pt x="1008" y="159"/>
                </a:lnTo>
                <a:lnTo>
                  <a:pt x="1006" y="225"/>
                </a:lnTo>
                <a:lnTo>
                  <a:pt x="962" y="281"/>
                </a:lnTo>
                <a:lnTo>
                  <a:pt x="904" y="320"/>
                </a:lnTo>
                <a:lnTo>
                  <a:pt x="849" y="350"/>
                </a:lnTo>
                <a:lnTo>
                  <a:pt x="782" y="375"/>
                </a:lnTo>
                <a:lnTo>
                  <a:pt x="709" y="397"/>
                </a:lnTo>
                <a:lnTo>
                  <a:pt x="626" y="420"/>
                </a:lnTo>
                <a:lnTo>
                  <a:pt x="557" y="441"/>
                </a:lnTo>
                <a:lnTo>
                  <a:pt x="493" y="458"/>
                </a:lnTo>
                <a:lnTo>
                  <a:pt x="432" y="474"/>
                </a:lnTo>
                <a:lnTo>
                  <a:pt x="366" y="484"/>
                </a:lnTo>
                <a:lnTo>
                  <a:pt x="296" y="493"/>
                </a:lnTo>
                <a:lnTo>
                  <a:pt x="229" y="495"/>
                </a:lnTo>
                <a:lnTo>
                  <a:pt x="160" y="486"/>
                </a:lnTo>
                <a:lnTo>
                  <a:pt x="99" y="471"/>
                </a:lnTo>
                <a:lnTo>
                  <a:pt x="49" y="424"/>
                </a:lnTo>
                <a:lnTo>
                  <a:pt x="21" y="367"/>
                </a:lnTo>
                <a:lnTo>
                  <a:pt x="16" y="306"/>
                </a:lnTo>
                <a:lnTo>
                  <a:pt x="47" y="241"/>
                </a:lnTo>
                <a:lnTo>
                  <a:pt x="100" y="195"/>
                </a:lnTo>
                <a:lnTo>
                  <a:pt x="154" y="160"/>
                </a:lnTo>
                <a:lnTo>
                  <a:pt x="222" y="135"/>
                </a:lnTo>
                <a:lnTo>
                  <a:pt x="286" y="111"/>
                </a:lnTo>
                <a:lnTo>
                  <a:pt x="347" y="98"/>
                </a:lnTo>
                <a:lnTo>
                  <a:pt x="410" y="86"/>
                </a:lnTo>
                <a:lnTo>
                  <a:pt x="473" y="73"/>
                </a:lnTo>
                <a:lnTo>
                  <a:pt x="536" y="60"/>
                </a:lnTo>
                <a:lnTo>
                  <a:pt x="599" y="48"/>
                </a:lnTo>
                <a:lnTo>
                  <a:pt x="663" y="35"/>
                </a:lnTo>
              </a:path>
            </a:pathLst>
          </a:custGeom>
          <a:noFill/>
          <a:ln w="21370" cap="sq">
            <a:solidFill>
              <a:srgbClr val="000000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2" name="path 42"/>
          <p:cNvSpPr/>
          <p:nvPr/>
        </p:nvSpPr>
        <p:spPr>
          <a:xfrm>
            <a:off x="758667" y="7447762"/>
            <a:ext cx="121101" cy="1075669"/>
          </a:xfrm>
          <a:custGeom>
            <a:avLst/>
            <a:gdLst/>
            <a:ahLst/>
            <a:cxnLst/>
            <a:rect l="0" t="0" r="0" b="0"/>
            <a:pathLst>
              <a:path w="190" h="1693">
                <a:moveTo>
                  <a:pt x="185" y="1688"/>
                </a:moveTo>
                <a:lnTo>
                  <a:pt x="95" y="1688"/>
                </a:lnTo>
                <a:moveTo>
                  <a:pt x="185" y="1609"/>
                </a:moveTo>
                <a:lnTo>
                  <a:pt x="95" y="1609"/>
                </a:lnTo>
                <a:moveTo>
                  <a:pt x="185" y="1542"/>
                </a:moveTo>
                <a:lnTo>
                  <a:pt x="5" y="1542"/>
                </a:lnTo>
                <a:moveTo>
                  <a:pt x="185" y="1463"/>
                </a:moveTo>
                <a:lnTo>
                  <a:pt x="95" y="1463"/>
                </a:lnTo>
                <a:moveTo>
                  <a:pt x="185" y="1396"/>
                </a:moveTo>
                <a:lnTo>
                  <a:pt x="95" y="1396"/>
                </a:lnTo>
                <a:moveTo>
                  <a:pt x="185" y="1318"/>
                </a:moveTo>
                <a:lnTo>
                  <a:pt x="95" y="1318"/>
                </a:lnTo>
                <a:moveTo>
                  <a:pt x="185" y="1250"/>
                </a:moveTo>
                <a:lnTo>
                  <a:pt x="5" y="1250"/>
                </a:lnTo>
                <a:moveTo>
                  <a:pt x="185" y="1172"/>
                </a:moveTo>
                <a:lnTo>
                  <a:pt x="95" y="1172"/>
                </a:lnTo>
                <a:moveTo>
                  <a:pt x="185" y="1105"/>
                </a:moveTo>
                <a:lnTo>
                  <a:pt x="95" y="1105"/>
                </a:lnTo>
                <a:moveTo>
                  <a:pt x="185" y="1026"/>
                </a:moveTo>
                <a:lnTo>
                  <a:pt x="95" y="1026"/>
                </a:lnTo>
                <a:moveTo>
                  <a:pt x="185" y="959"/>
                </a:moveTo>
                <a:lnTo>
                  <a:pt x="5" y="959"/>
                </a:lnTo>
                <a:moveTo>
                  <a:pt x="185" y="880"/>
                </a:moveTo>
                <a:lnTo>
                  <a:pt x="95" y="880"/>
                </a:lnTo>
                <a:moveTo>
                  <a:pt x="185" y="813"/>
                </a:moveTo>
                <a:lnTo>
                  <a:pt x="95" y="813"/>
                </a:lnTo>
                <a:moveTo>
                  <a:pt x="185" y="734"/>
                </a:moveTo>
                <a:lnTo>
                  <a:pt x="95" y="734"/>
                </a:lnTo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4" name="textbox 44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6" name="textbox 46"/>
          <p:cNvSpPr/>
          <p:nvPr/>
        </p:nvSpPr>
        <p:spPr>
          <a:xfrm>
            <a:off x="3805569" y="454610"/>
            <a:ext cx="495300" cy="2863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ct val="122000"/>
              </a:lnSpc>
              <a:tabLst>
                <a:tab pos="198120" algn="l"/>
              </a:tabLst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48" name="picture 4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818269" y="598385"/>
            <a:ext cx="121101" cy="99731"/>
          </a:xfrm>
          <a:prstGeom prst="rect">
            <a:avLst/>
          </a:prstGeom>
        </p:spPr>
      </p:pic>
      <p:pic>
        <p:nvPicPr>
          <p:cNvPr id="50" name="picture 5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477284"/>
            <a:ext cx="121101" cy="99730"/>
          </a:xfrm>
          <a:prstGeom prst="rect">
            <a:avLst/>
          </a:prstGeom>
        </p:spPr>
      </p:pic>
      <p:sp>
        <p:nvSpPr>
          <p:cNvPr id="52" name="textbox 52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4" name="textbox 54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6" name="textbox 56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8" name="path 58"/>
          <p:cNvSpPr/>
          <p:nvPr/>
        </p:nvSpPr>
        <p:spPr>
          <a:xfrm>
            <a:off x="787161" y="1563638"/>
            <a:ext cx="135349" cy="634003"/>
          </a:xfrm>
          <a:custGeom>
            <a:avLst/>
            <a:gdLst/>
            <a:ahLst/>
            <a:cxnLst/>
            <a:rect l="0" t="0" r="0" b="0"/>
            <a:pathLst>
              <a:path w="213" h="998">
                <a:moveTo>
                  <a:pt x="207" y="992"/>
                </a:moveTo>
                <a:lnTo>
                  <a:pt x="106" y="992"/>
                </a:lnTo>
                <a:moveTo>
                  <a:pt x="207" y="746"/>
                </a:moveTo>
                <a:lnTo>
                  <a:pt x="106" y="74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252"/>
                </a:moveTo>
                <a:lnTo>
                  <a:pt x="106" y="25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0" name="path 60"/>
          <p:cNvSpPr/>
          <p:nvPr/>
        </p:nvSpPr>
        <p:spPr>
          <a:xfrm>
            <a:off x="787161" y="3123714"/>
            <a:ext cx="135349" cy="626880"/>
          </a:xfrm>
          <a:custGeom>
            <a:avLst/>
            <a:gdLst/>
            <a:ahLst/>
            <a:cxnLst/>
            <a:rect l="0" t="0" r="0" b="0"/>
            <a:pathLst>
              <a:path w="213" h="987">
                <a:moveTo>
                  <a:pt x="207" y="981"/>
                </a:moveTo>
                <a:lnTo>
                  <a:pt x="106" y="981"/>
                </a:lnTo>
                <a:moveTo>
                  <a:pt x="207" y="734"/>
                </a:moveTo>
                <a:lnTo>
                  <a:pt x="106" y="734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252"/>
                </a:moveTo>
                <a:lnTo>
                  <a:pt x="106" y="25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path 62"/>
          <p:cNvSpPr/>
          <p:nvPr/>
        </p:nvSpPr>
        <p:spPr>
          <a:xfrm>
            <a:off x="787161" y="2347238"/>
            <a:ext cx="135349" cy="626880"/>
          </a:xfrm>
          <a:custGeom>
            <a:avLst/>
            <a:gdLst/>
            <a:ahLst/>
            <a:cxnLst/>
            <a:rect l="0" t="0" r="0" b="0"/>
            <a:pathLst>
              <a:path w="213" h="987">
                <a:moveTo>
                  <a:pt x="207" y="981"/>
                </a:moveTo>
                <a:lnTo>
                  <a:pt x="106" y="981"/>
                </a:lnTo>
                <a:moveTo>
                  <a:pt x="207" y="734"/>
                </a:moveTo>
                <a:lnTo>
                  <a:pt x="106" y="734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241"/>
                </a:moveTo>
                <a:lnTo>
                  <a:pt x="106" y="241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4" name="path 64"/>
          <p:cNvSpPr/>
          <p:nvPr/>
        </p:nvSpPr>
        <p:spPr>
          <a:xfrm>
            <a:off x="787161" y="787162"/>
            <a:ext cx="135349" cy="626879"/>
          </a:xfrm>
          <a:custGeom>
            <a:avLst/>
            <a:gdLst/>
            <a:ahLst/>
            <a:cxnLst/>
            <a:rect l="0" t="0" r="0" b="0"/>
            <a:pathLst>
              <a:path w="213" h="987">
                <a:moveTo>
                  <a:pt x="207" y="981"/>
                </a:moveTo>
                <a:lnTo>
                  <a:pt x="106" y="981"/>
                </a:lnTo>
                <a:moveTo>
                  <a:pt x="207" y="746"/>
                </a:moveTo>
                <a:lnTo>
                  <a:pt x="106" y="74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252"/>
                </a:moveTo>
                <a:lnTo>
                  <a:pt x="106" y="25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6" name="path 66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8" name="path 68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 70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 72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path 74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6" name="path 76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8" name="path 78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0" name="textbox 80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2" name="textbox 82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84" name="picture 8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86" name="textbox 86"/>
          <p:cNvSpPr/>
          <p:nvPr/>
        </p:nvSpPr>
        <p:spPr>
          <a:xfrm rot="16200000">
            <a:off x="5064821" y="7915550"/>
            <a:ext cx="259715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8" name="textbox 88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90" name="textbox 90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92" name="path 92"/>
          <p:cNvSpPr/>
          <p:nvPr/>
        </p:nvSpPr>
        <p:spPr>
          <a:xfrm>
            <a:off x="915387" y="787162"/>
            <a:ext cx="7123" cy="3120152"/>
          </a:xfrm>
          <a:custGeom>
            <a:avLst/>
            <a:gdLst/>
            <a:ahLst/>
            <a:cxnLst/>
            <a:rect l="0" t="0" r="0" b="0"/>
            <a:pathLst>
              <a:path w="11" h="4913">
                <a:moveTo>
                  <a:pt x="5" y="4908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rect 94"/>
          <p:cNvSpPr/>
          <p:nvPr/>
        </p:nvSpPr>
        <p:spPr>
          <a:xfrm>
            <a:off x="3381900" y="7613574"/>
            <a:ext cx="142473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rect 96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rect 98"/>
          <p:cNvSpPr/>
          <p:nvPr/>
        </p:nvSpPr>
        <p:spPr>
          <a:xfrm>
            <a:off x="1098199" y="7602667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0" name="textbox 100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2" name="textbox 102"/>
          <p:cNvSpPr/>
          <p:nvPr/>
        </p:nvSpPr>
        <p:spPr>
          <a:xfrm>
            <a:off x="1094927" y="7608361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4" name="textbox 104"/>
          <p:cNvSpPr/>
          <p:nvPr/>
        </p:nvSpPr>
        <p:spPr>
          <a:xfrm>
            <a:off x="3378609" y="7619269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6" name="path 106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path 108"/>
          <p:cNvSpPr/>
          <p:nvPr/>
        </p:nvSpPr>
        <p:spPr>
          <a:xfrm>
            <a:off x="815656" y="8559049"/>
            <a:ext cx="64112" cy="7123"/>
          </a:xfrm>
          <a:custGeom>
            <a:avLst/>
            <a:gdLst/>
            <a:ahLst/>
            <a:cxnLst/>
            <a:rect l="0" t="0" r="0" b="0"/>
            <a:pathLst>
              <a:path w="100" h="11"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0" name="path 110"/>
          <p:cNvSpPr/>
          <p:nvPr/>
        </p:nvSpPr>
        <p:spPr>
          <a:xfrm>
            <a:off x="872645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jQ5NjlkZjQ4NmY2YmRlZWY0ZDc5MDc2N2QzMGZhMDQifQ=="/>
</p:tagLst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"/>
        <a:ea typeface=""/>
        <a:cs typeface=""/>
      </a:majorFont>
      <a:minorFont>
        <a:latin typeface="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satMod val="110000"/>
                <a:lum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satMod val="105000"/>
                <a:lum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shade val="94000"/>
              </a:schemeClr>
            </a:gs>
            <a:gs pos="50000">
              <a:schemeClr val="phClr">
                <a:lumMod val="110000"/>
                <a:satMod val="100000"/>
                <a:tint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73</Words>
  <Application>WPS 演示</Application>
  <PresentationFormat/>
  <Paragraphs>18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Arial</vt:lpstr>
      <vt:lpstr>宋体</vt:lpstr>
      <vt:lpstr>Wingdings</vt:lpstr>
      <vt:lpstr>Arial</vt:lpstr>
      <vt:lpstr>微软雅黑</vt:lpstr>
      <vt:lpstr>Arial Unicode MS</vt:lpstr>
      <vt:lpstr>Calibri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格林</cp:lastModifiedBy>
  <cp:revision>2</cp:revision>
  <dcterms:created xsi:type="dcterms:W3CDTF">2024-03-05T14:44:00Z</dcterms:created>
  <dcterms:modified xsi:type="dcterms:W3CDTF">2024-09-07T16:13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O">
    <vt:lpwstr>wqlLaW5nc29mdCBQREYgdG8gV1BTIDkw</vt:lpwstr>
  </property>
  <property fmtid="{D5CDD505-2E9C-101B-9397-08002B2CF9AE}" pid="3" name="Created">
    <vt:filetime>2024-03-06T06:33:55Z</vt:filetime>
  </property>
  <property fmtid="{D5CDD505-2E9C-101B-9397-08002B2CF9AE}" pid="4" name="ICV">
    <vt:lpwstr>4A4B7679D12D418EA73AA11B46872FF2_12</vt:lpwstr>
  </property>
  <property fmtid="{D5CDD505-2E9C-101B-9397-08002B2CF9AE}" pid="5" name="KSOProductBuildVer">
    <vt:lpwstr>2052-12.1.0.16910</vt:lpwstr>
  </property>
</Properties>
</file>